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6" d="100"/>
          <a:sy n="116" d="100"/>
        </p:scale>
        <p:origin x="-1482" y="-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0.%20&#35838;&#39064;\00%20&#27743;&#20975;&#33673;%20FGFR\GZD824%20FGFR1%20manuscript\202011%20V561F-GZD824&#21160;&#29289;&#23454;&#39564;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.%20&#35838;&#39064;\00%20&#27743;&#20975;&#33673;%20FGFR\GZD824%20FGFR1%20manuscript\202011%20FGFR1-GZD824%20&#21160;&#29289;&#23454;&#39564;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0.%20&#35838;&#39064;\00%20&#27743;&#20975;&#33673;%20FGFR\GZD824%20FGFR1%20manuscript\&#20307;&#20869;\202009%20V561M-GZD824%20&#21160;&#29289;&#23454;&#39564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00"/>
            </a:pPr>
            <a:r>
              <a:rPr lang="en-US" sz="1000"/>
              <a:t>Ba/F3-TEL-FGFR1-V561F</a:t>
            </a:r>
            <a:endParaRPr lang="zh-CN" sz="1000"/>
          </a:p>
        </c:rich>
      </c:tx>
      <c:layout>
        <c:manualLayout>
          <c:xMode val="edge"/>
          <c:yMode val="edge"/>
          <c:x val="0.3079243055555555"/>
          <c:y val="4.7789444444444447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22467824449021176"/>
          <c:y val="0.16580309032375909"/>
          <c:w val="0.73593693885179456"/>
          <c:h val="0.6172545692725695"/>
        </c:manualLayout>
      </c:layout>
      <c:lineChart>
        <c:grouping val="standard"/>
        <c:varyColors val="0"/>
        <c:ser>
          <c:idx val="3"/>
          <c:order val="0"/>
          <c:tx>
            <c:strRef>
              <c:f>'D:\0. 课题\00 江凯莉 FGFR\GZD824 FGFR1 manuscript\[202011 FGFR1-GZD824 动物实验.xls]汇总'!$A$2</c:f>
              <c:strCache>
                <c:ptCount val="1"/>
                <c:pt idx="0">
                  <c:v>vehicle</c:v>
                </c:pt>
              </c:strCache>
            </c:strRef>
          </c:tx>
          <c:spPr>
            <a:ln w="25400">
              <a:solidFill>
                <a:schemeClr val="accent6">
                  <a:lumMod val="75000"/>
                </a:schemeClr>
              </a:solidFill>
              <a:prstDash val="solid"/>
            </a:ln>
          </c:spPr>
          <c:marker>
            <c:symbol val="x"/>
            <c:size val="5"/>
            <c:spPr>
              <a:solidFill>
                <a:schemeClr val="accent6">
                  <a:lumMod val="75000"/>
                </a:schemeClr>
              </a:solidFill>
              <a:ln>
                <a:solidFill>
                  <a:schemeClr val="accent6">
                    <a:lumMod val="75000"/>
                  </a:schemeClr>
                </a:solidFill>
                <a:prstDash val="solid"/>
              </a:ln>
            </c:spPr>
          </c:marker>
          <c:cat>
            <c:numRef>
              <c:f>'D:\0. 课题\00 江凯莉 FGFR\GZD824 FGFR1 manuscript\[202011 FGFR1-GZD824 动物实验.xls]汇总'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'D:\0. 课题\00 江凯莉 FGFR\GZD824 FGFR1 manuscript\[202011 FGFR1-GZD824 动物实验.xls]汇总'!$B$2:$H$2</c:f>
              <c:numCache>
                <c:formatCode>General</c:formatCode>
                <c:ptCount val="7"/>
                <c:pt idx="0">
                  <c:v>17.831666666666667</c:v>
                </c:pt>
                <c:pt idx="1">
                  <c:v>18.013333333333332</c:v>
                </c:pt>
                <c:pt idx="2">
                  <c:v>18.213333333333335</c:v>
                </c:pt>
                <c:pt idx="3">
                  <c:v>19.038333333333334</c:v>
                </c:pt>
                <c:pt idx="4">
                  <c:v>19.190000000000001</c:v>
                </c:pt>
                <c:pt idx="5">
                  <c:v>19.460000000000004</c:v>
                </c:pt>
                <c:pt idx="6">
                  <c:v>19.7883333333333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049-4804-8080-0FE00B443C0D}"/>
            </c:ext>
          </c:extLst>
        </c:ser>
        <c:ser>
          <c:idx val="4"/>
          <c:order val="1"/>
          <c:tx>
            <c:strRef>
              <c:f>'D:\0. 课题\00 江凯莉 FGFR\GZD824 FGFR1 manuscript\[202011 FGFR1-GZD824 动物实验.xls]汇总'!$A$3</c:f>
              <c:strCache>
                <c:ptCount val="1"/>
                <c:pt idx="0">
                  <c:v>BGJ398 10mg/kg </c:v>
                </c:pt>
              </c:strCache>
            </c:strRef>
          </c:tx>
          <c:spPr>
            <a:ln w="25400">
              <a:solidFill>
                <a:srgbClr val="ED7D31">
                  <a:lumMod val="50000"/>
                </a:srgbClr>
              </a:solidFill>
              <a:prstDash val="solid"/>
            </a:ln>
          </c:spPr>
          <c:marker>
            <c:symbol val="star"/>
            <c:size val="5"/>
            <c:spPr>
              <a:solidFill>
                <a:srgbClr val="ED7D31">
                  <a:lumMod val="50000"/>
                </a:srgbClr>
              </a:solidFill>
              <a:ln>
                <a:solidFill>
                  <a:schemeClr val="accent2">
                    <a:lumMod val="75000"/>
                  </a:schemeClr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:\0. 课题\00 江凯莉 FGFR\GZD824 FGFR1 manuscript\[202011 FGFR1-GZD824 动物实验.xls]汇总'!$B$27:$H$27</c:f>
                <c:numCache>
                  <c:formatCode>General</c:formatCode>
                  <c:ptCount val="7"/>
                  <c:pt idx="0">
                    <c:v>1.8775729013809292</c:v>
                  </c:pt>
                  <c:pt idx="1">
                    <c:v>1.5502311655577901</c:v>
                  </c:pt>
                  <c:pt idx="2">
                    <c:v>1.6525979547367227</c:v>
                  </c:pt>
                  <c:pt idx="3">
                    <c:v>1.3211472287372075</c:v>
                  </c:pt>
                  <c:pt idx="4">
                    <c:v>1.2519544720156561</c:v>
                  </c:pt>
                  <c:pt idx="5">
                    <c:v>1.1513296660817871</c:v>
                  </c:pt>
                  <c:pt idx="6">
                    <c:v>1.16830218693624</c:v>
                  </c:pt>
                </c:numCache>
              </c:numRef>
            </c:plus>
            <c:minus>
              <c:numRef>
                <c:f>'D:\0. 课题\00 江凯莉 FGFR\GZD824 FGFR1 manuscript\[202011 FGFR1-GZD824 动物实验.xls]汇总'!$B$27:$H$27</c:f>
                <c:numCache>
                  <c:formatCode>General</c:formatCode>
                  <c:ptCount val="7"/>
                  <c:pt idx="0">
                    <c:v>1.8775729013809292</c:v>
                  </c:pt>
                  <c:pt idx="1">
                    <c:v>1.5502311655577901</c:v>
                  </c:pt>
                  <c:pt idx="2">
                    <c:v>1.6525979547367227</c:v>
                  </c:pt>
                  <c:pt idx="3">
                    <c:v>1.3211472287372075</c:v>
                  </c:pt>
                  <c:pt idx="4">
                    <c:v>1.2519544720156561</c:v>
                  </c:pt>
                  <c:pt idx="5">
                    <c:v>1.1513296660817871</c:v>
                  </c:pt>
                  <c:pt idx="6">
                    <c:v>1.16830218693624</c:v>
                  </c:pt>
                </c:numCache>
              </c:numRef>
            </c:minus>
            <c:spPr>
              <a:ln w="22225">
                <a:solidFill>
                  <a:schemeClr val="accent2">
                    <a:lumMod val="75000"/>
                  </a:schemeClr>
                </a:solidFill>
              </a:ln>
            </c:spPr>
          </c:errBars>
          <c:cat>
            <c:numRef>
              <c:f>'D:\0. 课题\00 江凯莉 FGFR\GZD824 FGFR1 manuscript\[202011 FGFR1-GZD824 动物实验.xls]汇总'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'D:\0. 课题\00 江凯莉 FGFR\GZD824 FGFR1 manuscript\[202011 FGFR1-GZD824 动物实验.xls]汇总'!$B$3:$H$3</c:f>
              <c:numCache>
                <c:formatCode>General</c:formatCode>
                <c:ptCount val="7"/>
                <c:pt idx="0">
                  <c:v>18.210000000000004</c:v>
                </c:pt>
                <c:pt idx="1">
                  <c:v>18.358333333333334</c:v>
                </c:pt>
                <c:pt idx="2">
                  <c:v>18.279999999999998</c:v>
                </c:pt>
                <c:pt idx="3">
                  <c:v>18.304999999999996</c:v>
                </c:pt>
                <c:pt idx="4">
                  <c:v>18.264999999999997</c:v>
                </c:pt>
                <c:pt idx="5">
                  <c:v>18.27</c:v>
                </c:pt>
                <c:pt idx="6">
                  <c:v>18.14399999999999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049-4804-8080-0FE00B443C0D}"/>
            </c:ext>
          </c:extLst>
        </c:ser>
        <c:ser>
          <c:idx val="0"/>
          <c:order val="2"/>
          <c:tx>
            <c:strRef>
              <c:f>'D:\0. 课题\00 江凯莉 FGFR\GZD824 FGFR1 manuscript\[202011 FGFR1-GZD824 动物实验.xls]汇总'!$A$4</c:f>
              <c:strCache>
                <c:ptCount val="1"/>
                <c:pt idx="0">
                  <c:v>GZD824 10mg/kg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汇总!$B$28:$H$28</c:f>
                <c:numCache>
                  <c:formatCode>General</c:formatCode>
                  <c:ptCount val="7"/>
                  <c:pt idx="0">
                    <c:v>0.59089386149760859</c:v>
                  </c:pt>
                  <c:pt idx="1">
                    <c:v>0.62836339450635958</c:v>
                  </c:pt>
                  <c:pt idx="2">
                    <c:v>0.32526911934581249</c:v>
                  </c:pt>
                  <c:pt idx="3">
                    <c:v>0.13435028842544494</c:v>
                  </c:pt>
                  <c:pt idx="4">
                    <c:v>0.13435028842544494</c:v>
                  </c:pt>
                  <c:pt idx="5">
                    <c:v>0.22627416997969541</c:v>
                  </c:pt>
                  <c:pt idx="6">
                    <c:v>0.53740115370177477</c:v>
                  </c:pt>
                </c:numCache>
              </c:numRef>
            </c:plus>
            <c:minus>
              <c:numRef>
                <c:f>汇总!$B$28:$H$28</c:f>
                <c:numCache>
                  <c:formatCode>General</c:formatCode>
                  <c:ptCount val="7"/>
                  <c:pt idx="0">
                    <c:v>0.59089386149760859</c:v>
                  </c:pt>
                  <c:pt idx="1">
                    <c:v>0.62836339450635958</c:v>
                  </c:pt>
                  <c:pt idx="2">
                    <c:v>0.32526911934581249</c:v>
                  </c:pt>
                  <c:pt idx="3">
                    <c:v>0.13435028842544494</c:v>
                  </c:pt>
                  <c:pt idx="4">
                    <c:v>0.13435028842544494</c:v>
                  </c:pt>
                  <c:pt idx="5">
                    <c:v>0.22627416997969541</c:v>
                  </c:pt>
                  <c:pt idx="6">
                    <c:v>0.53740115370177477</c:v>
                  </c:pt>
                </c:numCache>
              </c:numRef>
            </c:minus>
            <c:spPr>
              <a:ln w="22225">
                <a:solidFill>
                  <a:schemeClr val="accent1">
                    <a:lumMod val="75000"/>
                  </a:schemeClr>
                </a:solidFill>
              </a:ln>
            </c:spPr>
          </c:errBars>
          <c:cat>
            <c:numRef>
              <c:f>'D:\0. 课题\00 江凯莉 FGFR\GZD824 FGFR1 manuscript\[202011 FGFR1-GZD824 动物实验.xls]汇总'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'D:\0. 课题\00 江凯莉 FGFR\GZD824 FGFR1 manuscript\[202011 FGFR1-GZD824 动物实验.xls]汇总'!$B$4:$H$4</c:f>
              <c:numCache>
                <c:formatCode>General</c:formatCode>
                <c:ptCount val="7"/>
                <c:pt idx="0">
                  <c:v>17.594999999999999</c:v>
                </c:pt>
                <c:pt idx="1">
                  <c:v>17.734999999999999</c:v>
                </c:pt>
                <c:pt idx="2">
                  <c:v>18.46</c:v>
                </c:pt>
                <c:pt idx="3">
                  <c:v>18.805</c:v>
                </c:pt>
                <c:pt idx="4">
                  <c:v>19.105</c:v>
                </c:pt>
                <c:pt idx="5">
                  <c:v>19.314999999999998</c:v>
                </c:pt>
                <c:pt idx="6">
                  <c:v>20.08500000000000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049-4804-8080-0FE00B443C0D}"/>
            </c:ext>
          </c:extLst>
        </c:ser>
        <c:ser>
          <c:idx val="1"/>
          <c:order val="3"/>
          <c:tx>
            <c:strRef>
              <c:f>'D:\0. 课题\00 江凯莉 FGFR\GZD824 FGFR1 manuscript\[202011 FGFR1-GZD824 动物实验.xls]汇总'!$A$5</c:f>
              <c:strCache>
                <c:ptCount val="1"/>
                <c:pt idx="0">
                  <c:v>GZD824 20mg/kg</c:v>
                </c:pt>
              </c:strCache>
            </c:strRef>
          </c:tx>
          <c:spPr>
            <a:ln w="25400">
              <a:solidFill>
                <a:srgbClr val="00B0F0"/>
              </a:solidFill>
            </a:ln>
          </c:spPr>
          <c:marker>
            <c:symbol val="square"/>
            <c:size val="5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汇总!$B$29:$H$29</c:f>
                <c:numCache>
                  <c:formatCode>General</c:formatCode>
                  <c:ptCount val="7"/>
                  <c:pt idx="0">
                    <c:v>1.3691684418734686</c:v>
                  </c:pt>
                  <c:pt idx="1">
                    <c:v>1.2914935367842744</c:v>
                  </c:pt>
                  <c:pt idx="2">
                    <c:v>1.4424978336205563</c:v>
                  </c:pt>
                  <c:pt idx="3">
                    <c:v>1.3152186130069781</c:v>
                  </c:pt>
                  <c:pt idx="4">
                    <c:v>1.1879393923933996</c:v>
                  </c:pt>
                  <c:pt idx="5">
                    <c:v>1.3788582233137672</c:v>
                  </c:pt>
                  <c:pt idx="6">
                    <c:v>1.5556349186104039</c:v>
                  </c:pt>
                </c:numCache>
              </c:numRef>
            </c:plus>
            <c:minus>
              <c:numRef>
                <c:f>汇总!$B$29:$H$29</c:f>
                <c:numCache>
                  <c:formatCode>General</c:formatCode>
                  <c:ptCount val="7"/>
                  <c:pt idx="0">
                    <c:v>1.3691684418734686</c:v>
                  </c:pt>
                  <c:pt idx="1">
                    <c:v>1.2914935367842744</c:v>
                  </c:pt>
                  <c:pt idx="2">
                    <c:v>1.4424978336205563</c:v>
                  </c:pt>
                  <c:pt idx="3">
                    <c:v>1.3152186130069781</c:v>
                  </c:pt>
                  <c:pt idx="4">
                    <c:v>1.1879393923933996</c:v>
                  </c:pt>
                  <c:pt idx="5">
                    <c:v>1.3788582233137672</c:v>
                  </c:pt>
                  <c:pt idx="6">
                    <c:v>1.5556349186104039</c:v>
                  </c:pt>
                </c:numCache>
              </c:numRef>
            </c:minus>
            <c:spPr>
              <a:ln w="25400">
                <a:solidFill>
                  <a:srgbClr val="00B0F0"/>
                </a:solidFill>
              </a:ln>
            </c:spPr>
          </c:errBars>
          <c:cat>
            <c:numRef>
              <c:f>'D:\0. 课题\00 江凯莉 FGFR\GZD824 FGFR1 manuscript\[202011 FGFR1-GZD824 动物实验.xls]汇总'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'D:\0. 课题\00 江凯莉 FGFR\GZD824 FGFR1 manuscript\[202011 FGFR1-GZD824 动物实验.xls]汇总'!$B$5:$H$5</c:f>
              <c:numCache>
                <c:formatCode>General</c:formatCode>
                <c:ptCount val="7"/>
                <c:pt idx="0">
                  <c:v>17.975000000000001</c:v>
                </c:pt>
                <c:pt idx="1">
                  <c:v>18.234999999999999</c:v>
                </c:pt>
                <c:pt idx="2">
                  <c:v>18.295000000000002</c:v>
                </c:pt>
                <c:pt idx="3">
                  <c:v>18.655000000000001</c:v>
                </c:pt>
                <c:pt idx="4">
                  <c:v>18.869999999999997</c:v>
                </c:pt>
                <c:pt idx="5">
                  <c:v>18.41</c:v>
                </c:pt>
                <c:pt idx="6">
                  <c:v>18.58500000000000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8049-4804-8080-0FE00B443C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2912512"/>
        <c:axId val="202914432"/>
      </c:lineChart>
      <c:catAx>
        <c:axId val="2029125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s post initial treatment（d）</a:t>
                </a:r>
              </a:p>
            </c:rich>
          </c:tx>
          <c:layout>
            <c:manualLayout>
              <c:xMode val="edge"/>
              <c:yMode val="edge"/>
              <c:x val="0.26983520314080661"/>
              <c:y val="0.90211311018767981"/>
            </c:manualLayout>
          </c:layout>
          <c:overlay val="0"/>
          <c:spPr>
            <a:noFill/>
            <a:ln w="25400">
              <a:noFill/>
            </a:ln>
          </c:spPr>
        </c:title>
        <c:numFmt formatCode="0_ 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zh-CN"/>
          </a:p>
        </c:txPr>
        <c:crossAx val="202914432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02914432"/>
        <c:scaling>
          <c:orientation val="minMax"/>
          <c:max val="25"/>
          <c:min val="1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Body weight（g）</a:t>
                </a:r>
              </a:p>
            </c:rich>
          </c:tx>
          <c:layout>
            <c:manualLayout>
              <c:xMode val="edge"/>
              <c:yMode val="edge"/>
              <c:x val="1.1668611435239206E-2"/>
              <c:y val="0.26943005181347152"/>
            </c:manualLayout>
          </c:layout>
          <c:overlay val="0"/>
          <c:spPr>
            <a:noFill/>
            <a:ln w="25400">
              <a:noFill/>
            </a:ln>
          </c:spPr>
        </c:title>
        <c:numFmt formatCode="0_);[Red]\(0\)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zh-CN"/>
          </a:p>
        </c:txPr>
        <c:crossAx val="202912512"/>
        <c:crosses val="autoZero"/>
        <c:crossBetween val="between"/>
        <c:majorUnit val="5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3698031821514356"/>
          <c:y val="0.49705715729028721"/>
          <c:w val="0.52583647578792081"/>
          <c:h val="0.23639477107159021"/>
        </c:manualLayout>
      </c:layout>
      <c:overlay val="0"/>
      <c:spPr>
        <a:solidFill>
          <a:srgbClr val="FFFFFF"/>
        </a:solidFill>
        <a:ln w="3175">
          <a:noFill/>
          <a:prstDash val="solid"/>
        </a:ln>
      </c:sp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800" b="1" i="0" u="none" strike="noStrike" baseline="0">
          <a:solidFill>
            <a:srgbClr val="000000"/>
          </a:solidFill>
          <a:latin typeface="Times New Roman" pitchFamily="18" charset="0"/>
          <a:ea typeface="宋体"/>
          <a:cs typeface="Times New Roman" pitchFamily="18" charset="0"/>
        </a:defRPr>
      </a:pPr>
      <a:endParaRPr lang="zh-CN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/>
              <a:t>Ba/F3-TEL-FGFR1</a:t>
            </a:r>
            <a:endParaRPr lang="zh-CN" sz="1000"/>
          </a:p>
        </c:rich>
      </c:tx>
      <c:layout>
        <c:manualLayout>
          <c:xMode val="edge"/>
          <c:yMode val="edge"/>
          <c:x val="0.3079243055555555"/>
          <c:y val="4.7789444444444447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21304300823078448"/>
          <c:y val="0.16580309032375909"/>
          <c:w val="0.74757217511122187"/>
          <c:h val="0.6172545692725695"/>
        </c:manualLayout>
      </c:layout>
      <c:lineChart>
        <c:grouping val="standard"/>
        <c:varyColors val="0"/>
        <c:ser>
          <c:idx val="3"/>
          <c:order val="0"/>
          <c:tx>
            <c:strRef>
              <c:f>汇总!$A$2</c:f>
              <c:strCache>
                <c:ptCount val="1"/>
                <c:pt idx="0">
                  <c:v>vehicle</c:v>
                </c:pt>
              </c:strCache>
            </c:strRef>
          </c:tx>
          <c:spPr>
            <a:ln w="25400">
              <a:solidFill>
                <a:schemeClr val="accent2"/>
              </a:solidFill>
              <a:prstDash val="solid"/>
            </a:ln>
          </c:spPr>
          <c:marker>
            <c:symbol val="x"/>
            <c:size val="5"/>
            <c:spPr>
              <a:solidFill>
                <a:schemeClr val="accent2"/>
              </a:solidFill>
              <a:ln>
                <a:solidFill>
                  <a:schemeClr val="accent2"/>
                </a:solidFill>
                <a:prstDash val="solid"/>
              </a:ln>
            </c:spPr>
          </c:marker>
          <c:cat>
            <c:numRef>
              <c:f>汇总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汇总!$B$2:$H$2</c:f>
              <c:numCache>
                <c:formatCode>0.0_);[Red]\(0.0\)</c:formatCode>
                <c:ptCount val="7"/>
                <c:pt idx="0">
                  <c:v>17.831666666666667</c:v>
                </c:pt>
                <c:pt idx="1">
                  <c:v>18.013333333333332</c:v>
                </c:pt>
                <c:pt idx="2">
                  <c:v>18.213333333333335</c:v>
                </c:pt>
                <c:pt idx="3">
                  <c:v>19.038333333333334</c:v>
                </c:pt>
                <c:pt idx="4">
                  <c:v>19.190000000000001</c:v>
                </c:pt>
                <c:pt idx="5">
                  <c:v>19.460000000000004</c:v>
                </c:pt>
                <c:pt idx="6">
                  <c:v>19.78833333333333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605-4F0A-9338-A7EB734899D4}"/>
            </c:ext>
          </c:extLst>
        </c:ser>
        <c:ser>
          <c:idx val="4"/>
          <c:order val="1"/>
          <c:tx>
            <c:strRef>
              <c:f>汇总!$A$3</c:f>
              <c:strCache>
                <c:ptCount val="1"/>
                <c:pt idx="0">
                  <c:v>BGJ398 10mg/kg </c:v>
                </c:pt>
              </c:strCache>
            </c:strRef>
          </c:tx>
          <c:spPr>
            <a:ln w="25400">
              <a:solidFill>
                <a:schemeClr val="accent2">
                  <a:lumMod val="75000"/>
                </a:schemeClr>
              </a:solidFill>
              <a:prstDash val="solid"/>
            </a:ln>
          </c:spPr>
          <c:marker>
            <c:symbol val="star"/>
            <c:size val="5"/>
            <c:spPr>
              <a:solidFill>
                <a:schemeClr val="accent2">
                  <a:lumMod val="75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汇总!$B$27:$H$27</c:f>
                <c:numCache>
                  <c:formatCode>General</c:formatCode>
                  <c:ptCount val="7"/>
                  <c:pt idx="0">
                    <c:v>1.8775729013809292</c:v>
                  </c:pt>
                  <c:pt idx="1">
                    <c:v>1.5502311655577901</c:v>
                  </c:pt>
                  <c:pt idx="2">
                    <c:v>1.6525979547367227</c:v>
                  </c:pt>
                  <c:pt idx="3">
                    <c:v>1.3211472287372075</c:v>
                  </c:pt>
                  <c:pt idx="4">
                    <c:v>1.2519544720156561</c:v>
                  </c:pt>
                  <c:pt idx="5">
                    <c:v>1.1513296660817871</c:v>
                  </c:pt>
                  <c:pt idx="6">
                    <c:v>1.16830218693624</c:v>
                  </c:pt>
                </c:numCache>
              </c:numRef>
            </c:plus>
            <c:minus>
              <c:numRef>
                <c:f>汇总!$B$27:$H$27</c:f>
                <c:numCache>
                  <c:formatCode>General</c:formatCode>
                  <c:ptCount val="7"/>
                  <c:pt idx="0">
                    <c:v>1.8775729013809292</c:v>
                  </c:pt>
                  <c:pt idx="1">
                    <c:v>1.5502311655577901</c:v>
                  </c:pt>
                  <c:pt idx="2">
                    <c:v>1.6525979547367227</c:v>
                  </c:pt>
                  <c:pt idx="3">
                    <c:v>1.3211472287372075</c:v>
                  </c:pt>
                  <c:pt idx="4">
                    <c:v>1.2519544720156561</c:v>
                  </c:pt>
                  <c:pt idx="5">
                    <c:v>1.1513296660817871</c:v>
                  </c:pt>
                  <c:pt idx="6">
                    <c:v>1.16830218693624</c:v>
                  </c:pt>
                </c:numCache>
              </c:numRef>
            </c:minus>
            <c:spPr>
              <a:ln w="22225">
                <a:solidFill>
                  <a:schemeClr val="accent2">
                    <a:lumMod val="75000"/>
                  </a:schemeClr>
                </a:solidFill>
              </a:ln>
            </c:spPr>
          </c:errBars>
          <c:cat>
            <c:numRef>
              <c:f>汇总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汇总!$B$3:$H$3</c:f>
              <c:numCache>
                <c:formatCode>0.0_);[Red]\(0.0\)</c:formatCode>
                <c:ptCount val="7"/>
                <c:pt idx="0">
                  <c:v>18.210000000000004</c:v>
                </c:pt>
                <c:pt idx="1">
                  <c:v>18.358333333333334</c:v>
                </c:pt>
                <c:pt idx="2">
                  <c:v>18.279999999999998</c:v>
                </c:pt>
                <c:pt idx="3">
                  <c:v>18.304999999999996</c:v>
                </c:pt>
                <c:pt idx="4">
                  <c:v>18.264999999999997</c:v>
                </c:pt>
                <c:pt idx="5">
                  <c:v>18.27</c:v>
                </c:pt>
                <c:pt idx="6">
                  <c:v>18.14399999999999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605-4F0A-9338-A7EB734899D4}"/>
            </c:ext>
          </c:extLst>
        </c:ser>
        <c:ser>
          <c:idx val="0"/>
          <c:order val="2"/>
          <c:tx>
            <c:strRef>
              <c:f>汇总!$A$4</c:f>
              <c:strCache>
                <c:ptCount val="1"/>
                <c:pt idx="0">
                  <c:v>GZD824 10mg/kg</c:v>
                </c:pt>
              </c:strCache>
            </c:strRef>
          </c:tx>
          <c:spPr>
            <a:ln w="25400">
              <a:solidFill>
                <a:srgbClr val="00B0F0"/>
              </a:solidFill>
            </a:ln>
          </c:spPr>
          <c:marker>
            <c:symbol val="diamond"/>
            <c:size val="7"/>
            <c:spPr>
              <a:solidFill>
                <a:srgbClr val="0070C0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汇总!$B$28:$H$28</c:f>
                <c:numCache>
                  <c:formatCode>General</c:formatCode>
                  <c:ptCount val="7"/>
                  <c:pt idx="0">
                    <c:v>1.2374368670764582</c:v>
                  </c:pt>
                  <c:pt idx="1">
                    <c:v>1.0111626970967629</c:v>
                  </c:pt>
                  <c:pt idx="2">
                    <c:v>0.76367532368147018</c:v>
                  </c:pt>
                  <c:pt idx="3">
                    <c:v>1.0535891039679572</c:v>
                  </c:pt>
                  <c:pt idx="4">
                    <c:v>0.70003571337468351</c:v>
                  </c:pt>
                  <c:pt idx="5">
                    <c:v>0.54447222151364127</c:v>
                  </c:pt>
                  <c:pt idx="6">
                    <c:v>0.5303300858899106</c:v>
                  </c:pt>
                </c:numCache>
              </c:numRef>
            </c:plus>
            <c:minus>
              <c:numRef>
                <c:f>汇总!$B$28:$H$28</c:f>
                <c:numCache>
                  <c:formatCode>General</c:formatCode>
                  <c:ptCount val="7"/>
                  <c:pt idx="0">
                    <c:v>1.2374368670764582</c:v>
                  </c:pt>
                  <c:pt idx="1">
                    <c:v>1.0111626970967629</c:v>
                  </c:pt>
                  <c:pt idx="2">
                    <c:v>0.76367532368147018</c:v>
                  </c:pt>
                  <c:pt idx="3">
                    <c:v>1.0535891039679572</c:v>
                  </c:pt>
                  <c:pt idx="4">
                    <c:v>0.70003571337468351</c:v>
                  </c:pt>
                  <c:pt idx="5">
                    <c:v>0.54447222151364127</c:v>
                  </c:pt>
                  <c:pt idx="6">
                    <c:v>0.5303300858899106</c:v>
                  </c:pt>
                </c:numCache>
              </c:numRef>
            </c:minus>
            <c:spPr>
              <a:ln w="22225">
                <a:solidFill>
                  <a:srgbClr val="0070C0"/>
                </a:solidFill>
              </a:ln>
            </c:spPr>
          </c:errBars>
          <c:cat>
            <c:numRef>
              <c:f>汇总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汇总!$B$4:$H$4</c:f>
              <c:numCache>
                <c:formatCode>0.0_);[Red]\(0.0\)</c:formatCode>
                <c:ptCount val="7"/>
                <c:pt idx="0">
                  <c:v>17.594999999999999</c:v>
                </c:pt>
                <c:pt idx="1">
                  <c:v>17.734999999999999</c:v>
                </c:pt>
                <c:pt idx="2">
                  <c:v>18.46</c:v>
                </c:pt>
                <c:pt idx="3">
                  <c:v>18.805</c:v>
                </c:pt>
                <c:pt idx="4">
                  <c:v>19.105</c:v>
                </c:pt>
                <c:pt idx="5">
                  <c:v>19.314999999999998</c:v>
                </c:pt>
                <c:pt idx="6">
                  <c:v>20.08500000000000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605-4F0A-9338-A7EB734899D4}"/>
            </c:ext>
          </c:extLst>
        </c:ser>
        <c:ser>
          <c:idx val="1"/>
          <c:order val="3"/>
          <c:tx>
            <c:strRef>
              <c:f>汇总!$A$5</c:f>
              <c:strCache>
                <c:ptCount val="1"/>
                <c:pt idx="0">
                  <c:v>GZD824 20mg/kg</c:v>
                </c:pt>
              </c:strCache>
            </c:strRef>
          </c:tx>
          <c:spPr>
            <a:ln w="25400">
              <a:solidFill>
                <a:srgbClr val="00B0F0"/>
              </a:solidFill>
            </a:ln>
          </c:spPr>
          <c:marker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汇总!$B$29:$H$29</c:f>
                <c:numCache>
                  <c:formatCode>General</c:formatCode>
                  <c:ptCount val="7"/>
                  <c:pt idx="0">
                    <c:v>1.0394469683442265</c:v>
                  </c:pt>
                  <c:pt idx="1">
                    <c:v>1.0677312395916854</c:v>
                  </c:pt>
                  <c:pt idx="2">
                    <c:v>0.6717514421272196</c:v>
                  </c:pt>
                  <c:pt idx="3">
                    <c:v>0.64346717087975835</c:v>
                  </c:pt>
                  <c:pt idx="4">
                    <c:v>0.82024386617639522</c:v>
                  </c:pt>
                  <c:pt idx="5">
                    <c:v>0.28284271247461801</c:v>
                  </c:pt>
                  <c:pt idx="6">
                    <c:v>0.5303300858899106</c:v>
                  </c:pt>
                </c:numCache>
              </c:numRef>
            </c:plus>
            <c:minus>
              <c:numRef>
                <c:f>汇总!$B$29:$H$29</c:f>
                <c:numCache>
                  <c:formatCode>General</c:formatCode>
                  <c:ptCount val="7"/>
                  <c:pt idx="0">
                    <c:v>1.0394469683442265</c:v>
                  </c:pt>
                  <c:pt idx="1">
                    <c:v>1.0677312395916854</c:v>
                  </c:pt>
                  <c:pt idx="2">
                    <c:v>0.6717514421272196</c:v>
                  </c:pt>
                  <c:pt idx="3">
                    <c:v>0.64346717087975835</c:v>
                  </c:pt>
                  <c:pt idx="4">
                    <c:v>0.82024386617639522</c:v>
                  </c:pt>
                  <c:pt idx="5">
                    <c:v>0.28284271247461801</c:v>
                  </c:pt>
                  <c:pt idx="6">
                    <c:v>0.5303300858899106</c:v>
                  </c:pt>
                </c:numCache>
              </c:numRef>
            </c:minus>
            <c:spPr>
              <a:ln w="19050">
                <a:solidFill>
                  <a:srgbClr val="00B0F0"/>
                </a:solidFill>
              </a:ln>
            </c:spPr>
          </c:errBars>
          <c:cat>
            <c:numRef>
              <c:f>汇总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汇总!$B$5:$H$5</c:f>
              <c:numCache>
                <c:formatCode>0.0_);[Red]\(0.0\)</c:formatCode>
                <c:ptCount val="7"/>
                <c:pt idx="0">
                  <c:v>17.975000000000001</c:v>
                </c:pt>
                <c:pt idx="1">
                  <c:v>18.234999999999999</c:v>
                </c:pt>
                <c:pt idx="2">
                  <c:v>18.295000000000002</c:v>
                </c:pt>
                <c:pt idx="3">
                  <c:v>18.655000000000001</c:v>
                </c:pt>
                <c:pt idx="4">
                  <c:v>18.869999999999997</c:v>
                </c:pt>
                <c:pt idx="5">
                  <c:v>18.41</c:v>
                </c:pt>
                <c:pt idx="6">
                  <c:v>18.58500000000000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605-4F0A-9338-A7EB734899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870016"/>
        <c:axId val="205104640"/>
      </c:lineChart>
      <c:catAx>
        <c:axId val="2048700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s post initial treatment（d）</a:t>
                </a:r>
              </a:p>
            </c:rich>
          </c:tx>
          <c:layout>
            <c:manualLayout>
              <c:xMode val="edge"/>
              <c:yMode val="edge"/>
              <c:x val="0.26983520314080661"/>
              <c:y val="0.90211311018767981"/>
            </c:manualLayout>
          </c:layout>
          <c:overlay val="0"/>
          <c:spPr>
            <a:noFill/>
            <a:ln w="25400">
              <a:noFill/>
            </a:ln>
          </c:spPr>
        </c:title>
        <c:numFmt formatCode="0_ 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zh-CN"/>
          </a:p>
        </c:txPr>
        <c:crossAx val="205104640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05104640"/>
        <c:scaling>
          <c:orientation val="minMax"/>
          <c:max val="25"/>
          <c:min val="1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Body weight（g）</a:t>
                </a:r>
              </a:p>
            </c:rich>
          </c:tx>
          <c:layout>
            <c:manualLayout>
              <c:xMode val="edge"/>
              <c:yMode val="edge"/>
              <c:x val="1.1668611435239206E-2"/>
              <c:y val="0.26943005181347152"/>
            </c:manualLayout>
          </c:layout>
          <c:overlay val="0"/>
          <c:spPr>
            <a:noFill/>
            <a:ln w="25400">
              <a:noFill/>
            </a:ln>
          </c:spPr>
        </c:title>
        <c:numFmt formatCode="0_);[Red]\(0\)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zh-CN"/>
          </a:p>
        </c:txPr>
        <c:crossAx val="204870016"/>
        <c:crosses val="autoZero"/>
        <c:crossBetween val="between"/>
        <c:majorUnit val="5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3698031821514356"/>
          <c:y val="0.49705715729028721"/>
          <c:w val="0.52583647578792081"/>
          <c:h val="0.23639477107159021"/>
        </c:manualLayout>
      </c:layout>
      <c:overlay val="0"/>
      <c:spPr>
        <a:solidFill>
          <a:srgbClr val="FFFFFF"/>
        </a:solidFill>
        <a:ln w="3175">
          <a:noFill/>
          <a:prstDash val="solid"/>
        </a:ln>
      </c:sp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800" b="1" i="0" u="none" strike="noStrike" baseline="0">
          <a:solidFill>
            <a:srgbClr val="000000"/>
          </a:solidFill>
          <a:latin typeface="Times New Roman" pitchFamily="18" charset="0"/>
          <a:ea typeface="宋体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/>
            </a:pPr>
            <a:r>
              <a:rPr lang="en-US" sz="1000"/>
              <a:t>Ba/F3-TEL-FGFR1-V561M</a:t>
            </a:r>
            <a:endParaRPr lang="zh-CN" sz="1000"/>
          </a:p>
        </c:rich>
      </c:tx>
      <c:layout>
        <c:manualLayout>
          <c:xMode val="edge"/>
          <c:yMode val="edge"/>
          <c:x val="0.3079243055555555"/>
          <c:y val="4.7789444444444447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2011567933412072"/>
          <c:y val="0.16580309032375909"/>
          <c:w val="0.75945875023933107"/>
          <c:h val="0.6172545692725695"/>
        </c:manualLayout>
      </c:layout>
      <c:lineChart>
        <c:grouping val="standard"/>
        <c:varyColors val="0"/>
        <c:ser>
          <c:idx val="3"/>
          <c:order val="0"/>
          <c:tx>
            <c:strRef>
              <c:f>汇总!$A$2</c:f>
              <c:strCache>
                <c:ptCount val="1"/>
                <c:pt idx="0">
                  <c:v>vehicle</c:v>
                </c:pt>
              </c:strCache>
            </c:strRef>
          </c:tx>
          <c:spPr>
            <a:ln w="25400">
              <a:solidFill>
                <a:schemeClr val="accent2"/>
              </a:solidFill>
              <a:prstDash val="solid"/>
            </a:ln>
          </c:spPr>
          <c:marker>
            <c:symbol val="x"/>
            <c:size val="5"/>
            <c:spPr>
              <a:solidFill>
                <a:schemeClr val="accent2"/>
              </a:solidFill>
              <a:ln>
                <a:solidFill>
                  <a:schemeClr val="accent2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汇总!$B$20:$H$20</c:f>
                <c:numCache>
                  <c:formatCode>General</c:formatCode>
                  <c:ptCount val="7"/>
                  <c:pt idx="0">
                    <c:v>0.65297524200130808</c:v>
                  </c:pt>
                  <c:pt idx="1">
                    <c:v>1.0242932522801595</c:v>
                  </c:pt>
                  <c:pt idx="2">
                    <c:v>0.88917189939103813</c:v>
                  </c:pt>
                  <c:pt idx="3">
                    <c:v>0.87628191810626732</c:v>
                  </c:pt>
                  <c:pt idx="4">
                    <c:v>0.75628037129096515</c:v>
                  </c:pt>
                  <c:pt idx="5">
                    <c:v>0.57038291232001859</c:v>
                  </c:pt>
                  <c:pt idx="6">
                    <c:v>0.8081254028099023</c:v>
                  </c:pt>
                </c:numCache>
              </c:numRef>
            </c:plus>
            <c:minus>
              <c:numRef>
                <c:f>汇总!$B$20:$H$20</c:f>
                <c:numCache>
                  <c:formatCode>General</c:formatCode>
                  <c:ptCount val="7"/>
                  <c:pt idx="0">
                    <c:v>0.65297524200130808</c:v>
                  </c:pt>
                  <c:pt idx="1">
                    <c:v>1.0242932522801595</c:v>
                  </c:pt>
                  <c:pt idx="2">
                    <c:v>0.88917189939103813</c:v>
                  </c:pt>
                  <c:pt idx="3">
                    <c:v>0.87628191810626732</c:v>
                  </c:pt>
                  <c:pt idx="4">
                    <c:v>0.75628037129096515</c:v>
                  </c:pt>
                  <c:pt idx="5">
                    <c:v>0.57038291232001859</c:v>
                  </c:pt>
                  <c:pt idx="6">
                    <c:v>0.8081254028099023</c:v>
                  </c:pt>
                </c:numCache>
              </c:numRef>
            </c:minus>
            <c:spPr>
              <a:ln w="19050">
                <a:solidFill>
                  <a:schemeClr val="accent2"/>
                </a:solidFill>
              </a:ln>
            </c:spPr>
          </c:errBars>
          <c:cat>
            <c:numRef>
              <c:f>汇总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汇总!$B$2:$H$2</c:f>
              <c:numCache>
                <c:formatCode>0.0_);[Red]\(0.0\)</c:formatCode>
                <c:ptCount val="7"/>
                <c:pt idx="0">
                  <c:v>17.901666666666667</c:v>
                </c:pt>
                <c:pt idx="1">
                  <c:v>18.57833333333333</c:v>
                </c:pt>
                <c:pt idx="2">
                  <c:v>18.796666666666667</c:v>
                </c:pt>
                <c:pt idx="3">
                  <c:v>19.364999999999998</c:v>
                </c:pt>
                <c:pt idx="4">
                  <c:v>19.5</c:v>
                </c:pt>
                <c:pt idx="5">
                  <c:v>20.12166666666667</c:v>
                </c:pt>
                <c:pt idx="6">
                  <c:v>19.77666666666666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B5B-445F-BAD7-0AB3471D3DEA}"/>
            </c:ext>
          </c:extLst>
        </c:ser>
        <c:ser>
          <c:idx val="4"/>
          <c:order val="1"/>
          <c:tx>
            <c:strRef>
              <c:f>汇总!$A$3</c:f>
              <c:strCache>
                <c:ptCount val="1"/>
                <c:pt idx="0">
                  <c:v>GZD824 10mg/kg</c:v>
                </c:pt>
              </c:strCache>
            </c:strRef>
          </c:tx>
          <c:spPr>
            <a:ln w="25400">
              <a:solidFill>
                <a:srgbClr val="0070C0"/>
              </a:solidFill>
              <a:prstDash val="solid"/>
            </a:ln>
          </c:spPr>
          <c:marker>
            <c:symbol val="star"/>
            <c:size val="5"/>
            <c:spPr>
              <a:solidFill>
                <a:srgbClr val="0070C0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汇总!$B$21:$H$21</c:f>
                <c:numCache>
                  <c:formatCode>General</c:formatCode>
                  <c:ptCount val="7"/>
                  <c:pt idx="0">
                    <c:v>0.59396969619669981</c:v>
                  </c:pt>
                  <c:pt idx="1">
                    <c:v>5.6568542494925107E-2</c:v>
                  </c:pt>
                  <c:pt idx="2">
                    <c:v>0.13435028842544242</c:v>
                  </c:pt>
                  <c:pt idx="3">
                    <c:v>4.9497474683058526E-2</c:v>
                  </c:pt>
                  <c:pt idx="4">
                    <c:v>0.40305086527633227</c:v>
                  </c:pt>
                  <c:pt idx="5">
                    <c:v>0.26162950903902327</c:v>
                  </c:pt>
                  <c:pt idx="6">
                    <c:v>0.14849242404917559</c:v>
                  </c:pt>
                </c:numCache>
              </c:numRef>
            </c:plus>
            <c:minus>
              <c:numRef>
                <c:f>汇总!$B$21:$H$21</c:f>
                <c:numCache>
                  <c:formatCode>General</c:formatCode>
                  <c:ptCount val="7"/>
                  <c:pt idx="0">
                    <c:v>0.59396969619669981</c:v>
                  </c:pt>
                  <c:pt idx="1">
                    <c:v>5.6568542494925107E-2</c:v>
                  </c:pt>
                  <c:pt idx="2">
                    <c:v>0.13435028842544242</c:v>
                  </c:pt>
                  <c:pt idx="3">
                    <c:v>4.9497474683058526E-2</c:v>
                  </c:pt>
                  <c:pt idx="4">
                    <c:v>0.40305086527633227</c:v>
                  </c:pt>
                  <c:pt idx="5">
                    <c:v>0.26162950903902327</c:v>
                  </c:pt>
                  <c:pt idx="6">
                    <c:v>0.14849242404917559</c:v>
                  </c:pt>
                </c:numCache>
              </c:numRef>
            </c:minus>
            <c:spPr>
              <a:ln w="25400">
                <a:solidFill>
                  <a:srgbClr val="0070C0"/>
                </a:solidFill>
              </a:ln>
            </c:spPr>
          </c:errBars>
          <c:cat>
            <c:numRef>
              <c:f>汇总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汇总!$B$3:$H$3</c:f>
              <c:numCache>
                <c:formatCode>0.0_);[Red]\(0.0\)</c:formatCode>
                <c:ptCount val="7"/>
                <c:pt idx="0">
                  <c:v>18.659999999999997</c:v>
                </c:pt>
                <c:pt idx="1">
                  <c:v>19.630000000000003</c:v>
                </c:pt>
                <c:pt idx="2">
                  <c:v>19.945</c:v>
                </c:pt>
                <c:pt idx="3">
                  <c:v>19.844999999999999</c:v>
                </c:pt>
                <c:pt idx="4">
                  <c:v>20.164999999999999</c:v>
                </c:pt>
                <c:pt idx="5">
                  <c:v>19.994999999999997</c:v>
                </c:pt>
                <c:pt idx="6">
                  <c:v>20.28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B5B-445F-BAD7-0AB3471D3DEA}"/>
            </c:ext>
          </c:extLst>
        </c:ser>
        <c:ser>
          <c:idx val="0"/>
          <c:order val="2"/>
          <c:tx>
            <c:strRef>
              <c:f>汇总!$A$4</c:f>
              <c:strCache>
                <c:ptCount val="1"/>
                <c:pt idx="0">
                  <c:v>GZD824 20mg/kg</c:v>
                </c:pt>
              </c:strCache>
            </c:strRef>
          </c:tx>
          <c:spPr>
            <a:ln w="25400">
              <a:solidFill>
                <a:srgbClr val="00B0F0"/>
              </a:solidFill>
            </a:ln>
          </c:spPr>
          <c:marker>
            <c:symbol val="square"/>
            <c:size val="5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汇总!$B$22:$H$22</c:f>
                <c:numCache>
                  <c:formatCode>General</c:formatCode>
                  <c:ptCount val="7"/>
                  <c:pt idx="0">
                    <c:v>2.2273863607376261</c:v>
                  </c:pt>
                  <c:pt idx="1">
                    <c:v>2.0011121907579308</c:v>
                  </c:pt>
                  <c:pt idx="2">
                    <c:v>2.1001071401240452</c:v>
                  </c:pt>
                  <c:pt idx="3">
                    <c:v>1.4000714267493644</c:v>
                  </c:pt>
                  <c:pt idx="4">
                    <c:v>1.7111984104714437</c:v>
                  </c:pt>
                  <c:pt idx="5">
                    <c:v>1.8950461735799471</c:v>
                  </c:pt>
                  <c:pt idx="6">
                    <c:v>2.4395183950935908</c:v>
                  </c:pt>
                </c:numCache>
              </c:numRef>
            </c:plus>
            <c:minus>
              <c:numRef>
                <c:f>汇总!$B$22:$H$22</c:f>
                <c:numCache>
                  <c:formatCode>General</c:formatCode>
                  <c:ptCount val="7"/>
                  <c:pt idx="0">
                    <c:v>2.2273863607376261</c:v>
                  </c:pt>
                  <c:pt idx="1">
                    <c:v>2.0011121907579308</c:v>
                  </c:pt>
                  <c:pt idx="2">
                    <c:v>2.1001071401240452</c:v>
                  </c:pt>
                  <c:pt idx="3">
                    <c:v>1.4000714267493644</c:v>
                  </c:pt>
                  <c:pt idx="4">
                    <c:v>1.7111984104714437</c:v>
                  </c:pt>
                  <c:pt idx="5">
                    <c:v>1.8950461735799471</c:v>
                  </c:pt>
                  <c:pt idx="6">
                    <c:v>2.4395183950935908</c:v>
                  </c:pt>
                </c:numCache>
              </c:numRef>
            </c:minus>
            <c:spPr>
              <a:ln w="25400">
                <a:solidFill>
                  <a:schemeClr val="accent1">
                    <a:lumMod val="75000"/>
                  </a:schemeClr>
                </a:solidFill>
              </a:ln>
            </c:spPr>
          </c:errBars>
          <c:cat>
            <c:numRef>
              <c:f>汇总!$B$1:$H$1</c:f>
              <c:numCache>
                <c:formatCode>General</c:formatCode>
                <c:ptCount val="7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</c:numCache>
            </c:numRef>
          </c:cat>
          <c:val>
            <c:numRef>
              <c:f>汇总!$B$4:$H$4</c:f>
              <c:numCache>
                <c:formatCode>0.0_);[Red]\(0.0\)</c:formatCode>
                <c:ptCount val="7"/>
                <c:pt idx="0">
                  <c:v>19.454999999999998</c:v>
                </c:pt>
                <c:pt idx="1">
                  <c:v>19.935000000000002</c:v>
                </c:pt>
                <c:pt idx="2">
                  <c:v>20.145</c:v>
                </c:pt>
                <c:pt idx="3">
                  <c:v>19.97</c:v>
                </c:pt>
                <c:pt idx="4">
                  <c:v>19.689999999999998</c:v>
                </c:pt>
                <c:pt idx="5">
                  <c:v>19.77</c:v>
                </c:pt>
                <c:pt idx="6">
                  <c:v>19.44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B5B-445F-BAD7-0AB3471D3D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7997952"/>
        <c:axId val="212382848"/>
      </c:lineChart>
      <c:catAx>
        <c:axId val="2079979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ys post initial treatment（d）</a:t>
                </a:r>
              </a:p>
            </c:rich>
          </c:tx>
          <c:layout>
            <c:manualLayout>
              <c:xMode val="edge"/>
              <c:yMode val="edge"/>
              <c:x val="0.26983520314080661"/>
              <c:y val="0.90211311018767981"/>
            </c:manualLayout>
          </c:layout>
          <c:overlay val="0"/>
          <c:spPr>
            <a:noFill/>
            <a:ln w="25400">
              <a:noFill/>
            </a:ln>
          </c:spPr>
        </c:title>
        <c:numFmt formatCode="0_ 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zh-CN"/>
          </a:p>
        </c:txPr>
        <c:crossAx val="21238284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212382848"/>
        <c:scaling>
          <c:orientation val="minMax"/>
          <c:max val="25"/>
          <c:min val="1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Body weight（g）</a:t>
                </a:r>
              </a:p>
            </c:rich>
          </c:tx>
          <c:layout>
            <c:manualLayout>
              <c:xMode val="edge"/>
              <c:yMode val="edge"/>
              <c:x val="1.1668611435239206E-2"/>
              <c:y val="0.26943005181347152"/>
            </c:manualLayout>
          </c:layout>
          <c:overlay val="0"/>
          <c:spPr>
            <a:noFill/>
            <a:ln w="25400">
              <a:noFill/>
            </a:ln>
          </c:spPr>
        </c:title>
        <c:numFmt formatCode="0_);[Red]\(0\)" sourceLinked="0"/>
        <c:majorTickMark val="in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zh-CN"/>
          </a:p>
        </c:txPr>
        <c:crossAx val="207997952"/>
        <c:crosses val="autoZero"/>
        <c:crossBetween val="between"/>
        <c:majorUnit val="5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3698031821514356"/>
          <c:y val="0.49705715729028721"/>
          <c:w val="0.54770044346170266"/>
          <c:h val="0.24439971574044478"/>
        </c:manualLayout>
      </c:layout>
      <c:overlay val="0"/>
      <c:spPr>
        <a:solidFill>
          <a:srgbClr val="FFFFFF"/>
        </a:solidFill>
        <a:ln w="3175">
          <a:noFill/>
          <a:prstDash val="solid"/>
        </a:ln>
      </c:sp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800" b="1" i="0" u="none" strike="noStrike" baseline="0">
          <a:solidFill>
            <a:srgbClr val="000000"/>
          </a:solidFill>
          <a:latin typeface="Times New Roman" pitchFamily="18" charset="0"/>
          <a:ea typeface="宋体"/>
          <a:cs typeface="Times New Roman" pitchFamily="18" charset="0"/>
        </a:defRPr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1646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5698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0384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7444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89617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5311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268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794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1463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2" y="273049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639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7779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4D0C4-E80D-41F1-A500-B61D5B360D39}" type="datetimeFigureOut">
              <a:rPr lang="zh-CN" altLang="en-US" smtClean="0"/>
              <a:t>2021/5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795627-40DF-4DC8-B9FC-1F90102E546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8331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13" Type="http://schemas.openxmlformats.org/officeDocument/2006/relationships/image" Target="../media/image17.png"/><Relationship Id="rId18" Type="http://schemas.openxmlformats.org/officeDocument/2006/relationships/image" Target="../media/image22.png"/><Relationship Id="rId26" Type="http://schemas.openxmlformats.org/officeDocument/2006/relationships/image" Target="../media/image30.tif"/><Relationship Id="rId3" Type="http://schemas.openxmlformats.org/officeDocument/2006/relationships/image" Target="../media/image7.tiff"/><Relationship Id="rId21" Type="http://schemas.openxmlformats.org/officeDocument/2006/relationships/image" Target="../media/image25.png"/><Relationship Id="rId7" Type="http://schemas.openxmlformats.org/officeDocument/2006/relationships/image" Target="../media/image11.tiff"/><Relationship Id="rId12" Type="http://schemas.openxmlformats.org/officeDocument/2006/relationships/image" Target="../media/image16.jpeg"/><Relationship Id="rId17" Type="http://schemas.openxmlformats.org/officeDocument/2006/relationships/image" Target="../media/image21.png"/><Relationship Id="rId25" Type="http://schemas.openxmlformats.org/officeDocument/2006/relationships/image" Target="../media/image29.tiff"/><Relationship Id="rId2" Type="http://schemas.openxmlformats.org/officeDocument/2006/relationships/image" Target="../media/image6.tiff"/><Relationship Id="rId16" Type="http://schemas.openxmlformats.org/officeDocument/2006/relationships/image" Target="../media/image20.png"/><Relationship Id="rId20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11" Type="http://schemas.openxmlformats.org/officeDocument/2006/relationships/image" Target="../media/image15.png"/><Relationship Id="rId24" Type="http://schemas.openxmlformats.org/officeDocument/2006/relationships/image" Target="../media/image28.png"/><Relationship Id="rId5" Type="http://schemas.openxmlformats.org/officeDocument/2006/relationships/image" Target="../media/image9.tiff"/><Relationship Id="rId15" Type="http://schemas.openxmlformats.org/officeDocument/2006/relationships/image" Target="../media/image19.png"/><Relationship Id="rId23" Type="http://schemas.openxmlformats.org/officeDocument/2006/relationships/image" Target="../media/image27.tif"/><Relationship Id="rId28" Type="http://schemas.openxmlformats.org/officeDocument/2006/relationships/image" Target="../media/image32.tif"/><Relationship Id="rId10" Type="http://schemas.openxmlformats.org/officeDocument/2006/relationships/image" Target="../media/image14.png"/><Relationship Id="rId19" Type="http://schemas.openxmlformats.org/officeDocument/2006/relationships/image" Target="../media/image23.png"/><Relationship Id="rId4" Type="http://schemas.openxmlformats.org/officeDocument/2006/relationships/image" Target="../media/image8.tiff"/><Relationship Id="rId9" Type="http://schemas.openxmlformats.org/officeDocument/2006/relationships/image" Target="../media/image13.png"/><Relationship Id="rId14" Type="http://schemas.openxmlformats.org/officeDocument/2006/relationships/image" Target="../media/image18.png"/><Relationship Id="rId22" Type="http://schemas.openxmlformats.org/officeDocument/2006/relationships/image" Target="../media/image26.png"/><Relationship Id="rId27" Type="http://schemas.openxmlformats.org/officeDocument/2006/relationships/image" Target="../media/image3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tiff"/><Relationship Id="rId2" Type="http://schemas.openxmlformats.org/officeDocument/2006/relationships/image" Target="../media/image3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png"/><Relationship Id="rId13" Type="http://schemas.openxmlformats.org/officeDocument/2006/relationships/image" Target="../media/image49.png"/><Relationship Id="rId3" Type="http://schemas.openxmlformats.org/officeDocument/2006/relationships/image" Target="../media/image39.png"/><Relationship Id="rId7" Type="http://schemas.openxmlformats.org/officeDocument/2006/relationships/image" Target="../media/image43.png"/><Relationship Id="rId12" Type="http://schemas.openxmlformats.org/officeDocument/2006/relationships/image" Target="../media/image48.png"/><Relationship Id="rId17" Type="http://schemas.openxmlformats.org/officeDocument/2006/relationships/image" Target="../media/image53.png"/><Relationship Id="rId2" Type="http://schemas.openxmlformats.org/officeDocument/2006/relationships/image" Target="../media/image38.png"/><Relationship Id="rId16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11" Type="http://schemas.openxmlformats.org/officeDocument/2006/relationships/image" Target="../media/image47.png"/><Relationship Id="rId5" Type="http://schemas.openxmlformats.org/officeDocument/2006/relationships/image" Target="../media/image41.png"/><Relationship Id="rId15" Type="http://schemas.openxmlformats.org/officeDocument/2006/relationships/image" Target="../media/image51.png"/><Relationship Id="rId10" Type="http://schemas.openxmlformats.org/officeDocument/2006/relationships/image" Target="../media/image46.png"/><Relationship Id="rId4" Type="http://schemas.openxmlformats.org/officeDocument/2006/relationships/image" Target="../media/image40.png"/><Relationship Id="rId9" Type="http://schemas.openxmlformats.org/officeDocument/2006/relationships/image" Target="../media/image45.png"/><Relationship Id="rId14" Type="http://schemas.openxmlformats.org/officeDocument/2006/relationships/image" Target="../media/image5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67578" y="2377442"/>
            <a:ext cx="5861785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0" b="1" dirty="0">
                <a:solidFill>
                  <a:srgbClr val="C00000"/>
                </a:solidFill>
              </a:rPr>
              <a:t>SI</a:t>
            </a:r>
          </a:p>
        </p:txBody>
      </p:sp>
    </p:spTree>
    <p:extLst>
      <p:ext uri="{BB962C8B-B14F-4D97-AF65-F5344CB8AC3E}">
        <p14:creationId xmlns:p14="http://schemas.microsoft.com/office/powerpoint/2010/main" val="326484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699792" y="1404370"/>
            <a:ext cx="2541816" cy="2401154"/>
            <a:chOff x="15995" y="1872761"/>
            <a:chExt cx="3389088" cy="2401153"/>
          </a:xfrm>
        </p:grpSpPr>
        <p:pic>
          <p:nvPicPr>
            <p:cNvPr id="3" name="图片 2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1047279" y="3735420"/>
              <a:ext cx="2160000" cy="288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4" name="图片 3"/>
            <p:cNvPicPr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1047279" y="2702790"/>
              <a:ext cx="2160000" cy="288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5" name="图片 4"/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1047279" y="3047000"/>
              <a:ext cx="2160000" cy="288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6" name="图片 5"/>
            <p:cNvPicPr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1047279" y="3391210"/>
              <a:ext cx="2160000" cy="288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8" name="文本框 9"/>
            <p:cNvSpPr txBox="1"/>
            <p:nvPr/>
          </p:nvSpPr>
          <p:spPr>
            <a:xfrm>
              <a:off x="15995" y="2735171"/>
              <a:ext cx="10123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文本框 10"/>
            <p:cNvSpPr txBox="1"/>
            <p:nvPr/>
          </p:nvSpPr>
          <p:spPr>
            <a:xfrm>
              <a:off x="304027" y="3047000"/>
              <a:ext cx="7243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2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11"/>
            <p:cNvSpPr txBox="1"/>
            <p:nvPr/>
          </p:nvSpPr>
          <p:spPr>
            <a:xfrm>
              <a:off x="304027" y="3392454"/>
              <a:ext cx="7243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3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2"/>
            <p:cNvSpPr txBox="1"/>
            <p:nvPr/>
          </p:nvSpPr>
          <p:spPr>
            <a:xfrm>
              <a:off x="304027" y="3726202"/>
              <a:ext cx="7243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4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1047279" y="4073112"/>
              <a:ext cx="2160000" cy="188946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14" name="文本框 15"/>
            <p:cNvSpPr txBox="1"/>
            <p:nvPr/>
          </p:nvSpPr>
          <p:spPr>
            <a:xfrm>
              <a:off x="15995" y="4058470"/>
              <a:ext cx="10123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5" name="组合 14"/>
            <p:cNvGrpSpPr/>
            <p:nvPr/>
          </p:nvGrpSpPr>
          <p:grpSpPr>
            <a:xfrm>
              <a:off x="1095114" y="1872761"/>
              <a:ext cx="2309969" cy="909604"/>
              <a:chOff x="1095114" y="1872761"/>
              <a:chExt cx="2309969" cy="909604"/>
            </a:xfrm>
          </p:grpSpPr>
          <p:sp>
            <p:nvSpPr>
              <p:cNvPr id="16" name="文本框 34"/>
              <p:cNvSpPr txBox="1"/>
              <p:nvPr/>
            </p:nvSpPr>
            <p:spPr>
              <a:xfrm rot="17520000">
                <a:off x="943786" y="2281894"/>
                <a:ext cx="589916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1581</a:t>
                </a:r>
              </a:p>
            </p:txBody>
          </p:sp>
          <p:sp>
            <p:nvSpPr>
              <p:cNvPr id="17" name="文本框 34"/>
              <p:cNvSpPr txBox="1"/>
              <p:nvPr/>
            </p:nvSpPr>
            <p:spPr>
              <a:xfrm rot="17520000">
                <a:off x="1251017" y="2281893"/>
                <a:ext cx="589915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549</a:t>
                </a:r>
              </a:p>
            </p:txBody>
          </p:sp>
          <p:sp>
            <p:nvSpPr>
              <p:cNvPr id="18" name="文本框 34"/>
              <p:cNvSpPr txBox="1"/>
              <p:nvPr/>
            </p:nvSpPr>
            <p:spPr>
              <a:xfrm rot="17520000">
                <a:off x="1082382" y="2281893"/>
                <a:ext cx="589915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-204</a:t>
                </a:r>
              </a:p>
            </p:txBody>
          </p:sp>
          <p:sp>
            <p:nvSpPr>
              <p:cNvPr id="19" name="文本框 34"/>
              <p:cNvSpPr txBox="1"/>
              <p:nvPr/>
            </p:nvSpPr>
            <p:spPr>
              <a:xfrm rot="17520000">
                <a:off x="1411192" y="2241539"/>
                <a:ext cx="693610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ATOIII</a:t>
                </a:r>
              </a:p>
            </p:txBody>
          </p:sp>
          <p:sp>
            <p:nvSpPr>
              <p:cNvPr id="20" name="文本框 34"/>
              <p:cNvSpPr txBox="1"/>
              <p:nvPr/>
            </p:nvSpPr>
            <p:spPr>
              <a:xfrm rot="17520000">
                <a:off x="1787936" y="2280156"/>
                <a:ext cx="717159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CI-H716</a:t>
                </a:r>
              </a:p>
            </p:txBody>
          </p:sp>
          <p:sp>
            <p:nvSpPr>
              <p:cNvPr id="21" name="文本框 34"/>
              <p:cNvSpPr txBox="1"/>
              <p:nvPr/>
            </p:nvSpPr>
            <p:spPr>
              <a:xfrm rot="17520000">
                <a:off x="1585234" y="2246139"/>
                <a:ext cx="667039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NU-16</a:t>
                </a:r>
              </a:p>
            </p:txBody>
          </p:sp>
          <p:sp>
            <p:nvSpPr>
              <p:cNvPr id="22" name="文本框 34"/>
              <p:cNvSpPr txBox="1"/>
              <p:nvPr/>
            </p:nvSpPr>
            <p:spPr>
              <a:xfrm rot="17520000">
                <a:off x="2031618" y="2281893"/>
                <a:ext cx="589915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T4</a:t>
                </a:r>
              </a:p>
            </p:txBody>
          </p:sp>
          <p:sp>
            <p:nvSpPr>
              <p:cNvPr id="23" name="文本框 34"/>
              <p:cNvSpPr txBox="1"/>
              <p:nvPr/>
            </p:nvSpPr>
            <p:spPr>
              <a:xfrm rot="17520000">
                <a:off x="2300875" y="2159090"/>
                <a:ext cx="859917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A-MB-453</a:t>
                </a:r>
              </a:p>
            </p:txBody>
          </p:sp>
          <p:sp>
            <p:nvSpPr>
              <p:cNvPr id="24" name="文本框 34"/>
              <p:cNvSpPr txBox="1"/>
              <p:nvPr/>
            </p:nvSpPr>
            <p:spPr>
              <a:xfrm rot="17520000">
                <a:off x="2204301" y="2281894"/>
                <a:ext cx="589915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T112</a:t>
                </a:r>
              </a:p>
            </p:txBody>
          </p:sp>
          <p:sp>
            <p:nvSpPr>
              <p:cNvPr id="25" name="文本框 34"/>
              <p:cNvSpPr txBox="1"/>
              <p:nvPr/>
            </p:nvSpPr>
            <p:spPr>
              <a:xfrm rot="17520000">
                <a:off x="2546228" y="2281894"/>
                <a:ext cx="589915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uH-7</a:t>
                </a:r>
              </a:p>
            </p:txBody>
          </p:sp>
          <p:sp>
            <p:nvSpPr>
              <p:cNvPr id="26" name="文本框 34"/>
              <p:cNvSpPr txBox="1"/>
              <p:nvPr/>
            </p:nvSpPr>
            <p:spPr>
              <a:xfrm rot="17520000">
                <a:off x="2831057" y="2161865"/>
                <a:ext cx="860793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DA-MB-231</a:t>
                </a:r>
              </a:p>
            </p:txBody>
          </p:sp>
          <p:sp>
            <p:nvSpPr>
              <p:cNvPr id="27" name="文本框 34"/>
              <p:cNvSpPr txBox="1"/>
              <p:nvPr/>
            </p:nvSpPr>
            <p:spPr>
              <a:xfrm rot="17520000">
                <a:off x="2650980" y="2205406"/>
                <a:ext cx="755127" cy="2872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ep3B  21-7</a:t>
                </a:r>
              </a:p>
            </p:txBody>
          </p:sp>
        </p:grpSp>
      </p:grpSp>
      <p:sp>
        <p:nvSpPr>
          <p:cNvPr id="28" name="矩形 27"/>
          <p:cNvSpPr/>
          <p:nvPr/>
        </p:nvSpPr>
        <p:spPr>
          <a:xfrm>
            <a:off x="2011684" y="4321353"/>
            <a:ext cx="4572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Expression of FGFR1-4 in different cancer cells.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collected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sise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RIPA lysis buffer , and protein quantity was adjusted by  BCA kit and 5X SDS. Then the expression level of FGFR1-4 and phosphorylated FGFR in those cancer cell lines was detected by western blotting(WB). GAPDH was used as a control.</a:t>
            </a:r>
          </a:p>
          <a:p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1894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 txBox="1">
            <a:spLocks/>
          </p:cNvSpPr>
          <p:nvPr/>
        </p:nvSpPr>
        <p:spPr>
          <a:xfrm>
            <a:off x="961349" y="4405185"/>
            <a:ext cx="7272808" cy="1456599"/>
          </a:xfrm>
          <a:prstGeom prst="rect">
            <a:avLst/>
          </a:prstGeom>
        </p:spPr>
        <p:txBody>
          <a:bodyPr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Effects of reported FGFRs inhibitor on  FGFR-WT and V561M/F mutant resistance </a:t>
            </a:r>
            <a:r>
              <a:rPr lang="en-US" altLang="zh-CN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BAF3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s</a:t>
            </a:r>
          </a:p>
          <a:p>
            <a:pPr algn="l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treated with or without compound BGJ398,TAS120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migatini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4 h at the indicate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,the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arvested and lysed. Cell lysates were separated by sodium dodecyl sulfate-polyacrylamide gel electrophoresis (SDS-PAGE) and analyzed by Western blot for phosphorylated FGFR1,FGFR1,phosphorylated FRS2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S2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osphorylated AKT(Ser473),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KT,phosphorylate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GAPDH was used as a control.</a:t>
            </a:r>
          </a:p>
          <a:p>
            <a:pPr algn="l"/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1399743" y="1056501"/>
            <a:ext cx="6124778" cy="2862212"/>
            <a:chOff x="1399743" y="1056501"/>
            <a:chExt cx="6124778" cy="2862212"/>
          </a:xfrm>
        </p:grpSpPr>
        <p:pic>
          <p:nvPicPr>
            <p:cNvPr id="3" name="图片 2"/>
            <p:cNvPicPr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26122" y="2188223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5" name="图片 4"/>
            <p:cNvPicPr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26122" y="3720264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8" name="图片 7"/>
            <p:cNvPicPr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26122" y="2846204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0" name="图片 9"/>
            <p:cNvPicPr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26122" y="3064719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1" name="图片 10"/>
            <p:cNvPicPr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26122" y="3501749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2" name="图片 11"/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26122" y="3283234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3" name="图片 12"/>
            <p:cNvPicPr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26122" y="1969708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166" name="文本框 1"/>
            <p:cNvSpPr txBox="1"/>
            <p:nvPr/>
          </p:nvSpPr>
          <p:spPr>
            <a:xfrm>
              <a:off x="1688962" y="3479770"/>
              <a:ext cx="4155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K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文本框 2"/>
            <p:cNvSpPr txBox="1"/>
            <p:nvPr/>
          </p:nvSpPr>
          <p:spPr>
            <a:xfrm>
              <a:off x="1399743" y="3703269"/>
              <a:ext cx="7047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文本框 3"/>
            <p:cNvSpPr txBox="1"/>
            <p:nvPr/>
          </p:nvSpPr>
          <p:spPr>
            <a:xfrm>
              <a:off x="1572489" y="3256275"/>
              <a:ext cx="5320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文本框 5"/>
            <p:cNvSpPr txBox="1"/>
            <p:nvPr/>
          </p:nvSpPr>
          <p:spPr>
            <a:xfrm>
              <a:off x="1594212" y="3032779"/>
              <a:ext cx="5103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文本框 7"/>
            <p:cNvSpPr txBox="1"/>
            <p:nvPr/>
          </p:nvSpPr>
          <p:spPr>
            <a:xfrm>
              <a:off x="1593092" y="2151022"/>
              <a:ext cx="5114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文本框 8"/>
            <p:cNvSpPr txBox="1"/>
            <p:nvPr/>
          </p:nvSpPr>
          <p:spPr>
            <a:xfrm>
              <a:off x="1399743" y="1927526"/>
              <a:ext cx="7047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FGFR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文本框 9"/>
            <p:cNvSpPr txBox="1"/>
            <p:nvPr/>
          </p:nvSpPr>
          <p:spPr>
            <a:xfrm>
              <a:off x="1572489" y="2809283"/>
              <a:ext cx="5320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K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TextBox 257"/>
            <p:cNvSpPr txBox="1"/>
            <p:nvPr/>
          </p:nvSpPr>
          <p:spPr>
            <a:xfrm>
              <a:off x="2333149" y="1128590"/>
              <a:ext cx="8281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F3-FGFR1</a:t>
              </a:r>
            </a:p>
          </p:txBody>
        </p:sp>
        <p:sp>
          <p:nvSpPr>
            <p:cNvPr id="299" name="矩形 298"/>
            <p:cNvSpPr/>
            <p:nvPr/>
          </p:nvSpPr>
          <p:spPr>
            <a:xfrm>
              <a:off x="1399743" y="1730925"/>
              <a:ext cx="79701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.</a:t>
              </a:r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（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）</a:t>
              </a:r>
            </a:p>
          </p:txBody>
        </p:sp>
        <p:grpSp>
          <p:nvGrpSpPr>
            <p:cNvPr id="28" name="组合 27"/>
            <p:cNvGrpSpPr/>
            <p:nvPr/>
          </p:nvGrpSpPr>
          <p:grpSpPr>
            <a:xfrm>
              <a:off x="2128624" y="1386823"/>
              <a:ext cx="1363256" cy="584347"/>
              <a:chOff x="6507901" y="910215"/>
              <a:chExt cx="1817675" cy="584347"/>
            </a:xfrm>
          </p:grpSpPr>
          <p:sp>
            <p:nvSpPr>
              <p:cNvPr id="152" name="文本框 62"/>
              <p:cNvSpPr txBox="1"/>
              <p:nvPr/>
            </p:nvSpPr>
            <p:spPr>
              <a:xfrm>
                <a:off x="7031438" y="910215"/>
                <a:ext cx="91009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ctr">
                  <a:defRPr sz="800" b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600" dirty="0" err="1">
                    <a:solidFill>
                      <a:schemeClr val="tx1"/>
                    </a:solidFill>
                  </a:rPr>
                  <a:t>pemigatinib</a:t>
                </a:r>
                <a:endParaRPr lang="zh-CN" altLang="en-US" sz="6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3" name="文本框 63"/>
              <p:cNvSpPr txBox="1"/>
              <p:nvPr/>
            </p:nvSpPr>
            <p:spPr>
              <a:xfrm>
                <a:off x="7643823" y="918244"/>
                <a:ext cx="68175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ctr">
                  <a:defRPr sz="800" b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700" dirty="0">
                    <a:solidFill>
                      <a:schemeClr val="tx1"/>
                    </a:solidFill>
                  </a:rPr>
                  <a:t>TAS120</a:t>
                </a:r>
                <a:endParaRPr lang="zh-CN" altLang="en-US" sz="7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5" name="文本框 64"/>
              <p:cNvSpPr txBox="1"/>
              <p:nvPr/>
            </p:nvSpPr>
            <p:spPr>
              <a:xfrm>
                <a:off x="6620010" y="920034"/>
                <a:ext cx="68175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ctr">
                  <a:defRPr sz="800" b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700" dirty="0">
                    <a:solidFill>
                      <a:schemeClr val="tx1"/>
                    </a:solidFill>
                  </a:rPr>
                  <a:t>BGJ398</a:t>
                </a:r>
                <a:endParaRPr lang="zh-CN" altLang="en-US" sz="7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177" name="直接连接符 176"/>
              <p:cNvCxnSpPr/>
              <p:nvPr/>
            </p:nvCxnSpPr>
            <p:spPr>
              <a:xfrm>
                <a:off x="6721623" y="1137422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直接连接符 255"/>
              <p:cNvCxnSpPr/>
              <p:nvPr/>
            </p:nvCxnSpPr>
            <p:spPr>
              <a:xfrm>
                <a:off x="7226448" y="1137422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直接连接符 297"/>
              <p:cNvCxnSpPr/>
              <p:nvPr/>
            </p:nvCxnSpPr>
            <p:spPr>
              <a:xfrm>
                <a:off x="7702698" y="1137422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" name="组合 26"/>
              <p:cNvGrpSpPr/>
              <p:nvPr/>
            </p:nvGrpSpPr>
            <p:grpSpPr>
              <a:xfrm>
                <a:off x="6507901" y="1039020"/>
                <a:ext cx="1707038" cy="455542"/>
                <a:chOff x="9176296" y="1266205"/>
                <a:chExt cx="1707038" cy="455542"/>
              </a:xfrm>
            </p:grpSpPr>
            <p:sp>
              <p:nvSpPr>
                <p:cNvPr id="331" name="文本框 50"/>
                <p:cNvSpPr txBox="1"/>
                <p:nvPr/>
              </p:nvSpPr>
              <p:spPr>
                <a:xfrm rot="17520000">
                  <a:off x="9271650" y="1367835"/>
                  <a:ext cx="417819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.3</a:t>
                  </a:r>
                </a:p>
              </p:txBody>
            </p:sp>
            <p:sp>
              <p:nvSpPr>
                <p:cNvPr id="332" name="文本框 51"/>
                <p:cNvSpPr txBox="1"/>
                <p:nvPr/>
              </p:nvSpPr>
              <p:spPr>
                <a:xfrm rot="17520000">
                  <a:off x="9433768" y="1368083"/>
                  <a:ext cx="417281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333" name="文本框 52"/>
                <p:cNvSpPr txBox="1"/>
                <p:nvPr/>
              </p:nvSpPr>
              <p:spPr>
                <a:xfrm rot="17520000">
                  <a:off x="9584762" y="1350346"/>
                  <a:ext cx="455542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334" name="文本框 55"/>
                <p:cNvSpPr txBox="1"/>
                <p:nvPr/>
              </p:nvSpPr>
              <p:spPr>
                <a:xfrm rot="17520000">
                  <a:off x="9764763" y="1367835"/>
                  <a:ext cx="417819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.3</a:t>
                  </a:r>
                </a:p>
              </p:txBody>
            </p:sp>
            <p:sp>
              <p:nvSpPr>
                <p:cNvPr id="335" name="文本框 56"/>
                <p:cNvSpPr txBox="1"/>
                <p:nvPr/>
              </p:nvSpPr>
              <p:spPr>
                <a:xfrm rot="17520000">
                  <a:off x="9923205" y="1368083"/>
                  <a:ext cx="417281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336" name="文本框 57"/>
                <p:cNvSpPr txBox="1"/>
                <p:nvPr/>
              </p:nvSpPr>
              <p:spPr>
                <a:xfrm rot="17520000">
                  <a:off x="10069328" y="1350346"/>
                  <a:ext cx="455542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337" name="文本框 58"/>
                <p:cNvSpPr txBox="1"/>
                <p:nvPr/>
              </p:nvSpPr>
              <p:spPr>
                <a:xfrm rot="17520000">
                  <a:off x="10231304" y="1367835"/>
                  <a:ext cx="417819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.3</a:t>
                  </a:r>
                </a:p>
              </p:txBody>
            </p:sp>
            <p:sp>
              <p:nvSpPr>
                <p:cNvPr id="338" name="文本框 59"/>
                <p:cNvSpPr txBox="1"/>
                <p:nvPr/>
              </p:nvSpPr>
              <p:spPr>
                <a:xfrm rot="17520000">
                  <a:off x="10378458" y="1368083"/>
                  <a:ext cx="417281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339" name="文本框 60"/>
                <p:cNvSpPr txBox="1"/>
                <p:nvPr/>
              </p:nvSpPr>
              <p:spPr>
                <a:xfrm rot="17520000">
                  <a:off x="10511934" y="1350346"/>
                  <a:ext cx="455542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340" name="文本框 61"/>
                <p:cNvSpPr txBox="1"/>
                <p:nvPr/>
              </p:nvSpPr>
              <p:spPr>
                <a:xfrm rot="17520000">
                  <a:off x="9119766" y="1375946"/>
                  <a:ext cx="400320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</p:grpSp>
        </p:grpSp>
        <p:pic>
          <p:nvPicPr>
            <p:cNvPr id="189" name="图片 188"/>
            <p:cNvPicPr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6204" y="1969708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90" name="图片 189"/>
            <p:cNvPicPr>
              <a:picLocks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6204" y="2188527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91" name="图片 190"/>
            <p:cNvPicPr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6204" y="3282622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92" name="图片 191"/>
            <p:cNvPicPr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6204" y="3501441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94" name="图片 193"/>
            <p:cNvPicPr>
              <a:picLocks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6204" y="3063803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95" name="图片 194"/>
            <p:cNvPicPr>
              <a:picLocks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6204" y="3720264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6" name="图片 5"/>
            <p:cNvPicPr>
              <a:picLocks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6204" y="2844984"/>
              <a:ext cx="1214931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403" name="TextBox 402"/>
            <p:cNvSpPr txBox="1"/>
            <p:nvPr/>
          </p:nvSpPr>
          <p:spPr>
            <a:xfrm>
              <a:off x="4139952" y="1128590"/>
              <a:ext cx="138864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F3-FGFR1-V561F</a:t>
              </a:r>
            </a:p>
          </p:txBody>
        </p:sp>
        <p:grpSp>
          <p:nvGrpSpPr>
            <p:cNvPr id="408" name="组合 407"/>
            <p:cNvGrpSpPr/>
            <p:nvPr/>
          </p:nvGrpSpPr>
          <p:grpSpPr>
            <a:xfrm>
              <a:off x="4137245" y="1386823"/>
              <a:ext cx="1382440" cy="574527"/>
              <a:chOff x="6453749" y="920034"/>
              <a:chExt cx="1843254" cy="574527"/>
            </a:xfrm>
          </p:grpSpPr>
          <p:sp>
            <p:nvSpPr>
              <p:cNvPr id="409" name="文本框 62"/>
              <p:cNvSpPr txBox="1"/>
              <p:nvPr/>
            </p:nvSpPr>
            <p:spPr>
              <a:xfrm>
                <a:off x="7099240" y="929265"/>
                <a:ext cx="75764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ctr">
                  <a:defRPr sz="800" b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700" dirty="0">
                    <a:solidFill>
                      <a:schemeClr val="tx1"/>
                    </a:solidFill>
                  </a:rPr>
                  <a:t>TAS120</a:t>
                </a:r>
                <a:endParaRPr lang="zh-CN" altLang="en-US" sz="7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10" name="文本框 63"/>
              <p:cNvSpPr txBox="1"/>
              <p:nvPr/>
            </p:nvSpPr>
            <p:spPr>
              <a:xfrm>
                <a:off x="7615248" y="927769"/>
                <a:ext cx="68175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ctr">
                  <a:defRPr sz="800" b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700" dirty="0">
                    <a:solidFill>
                      <a:schemeClr val="tx1"/>
                    </a:solidFill>
                  </a:rPr>
                  <a:t>BGJ398</a:t>
                </a:r>
                <a:endParaRPr lang="zh-CN" altLang="en-US" sz="7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11" name="文本框 64"/>
              <p:cNvSpPr txBox="1"/>
              <p:nvPr/>
            </p:nvSpPr>
            <p:spPr>
              <a:xfrm>
                <a:off x="6453749" y="920034"/>
                <a:ext cx="86770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ctr">
                  <a:defRPr sz="800" b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700" dirty="0" err="1">
                    <a:solidFill>
                      <a:schemeClr val="tx1"/>
                    </a:solidFill>
                  </a:rPr>
                  <a:t>pemigatinib</a:t>
                </a:r>
                <a:endParaRPr lang="zh-CN" altLang="en-US" sz="7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412" name="直接连接符 411"/>
              <p:cNvCxnSpPr/>
              <p:nvPr/>
            </p:nvCxnSpPr>
            <p:spPr>
              <a:xfrm>
                <a:off x="6721623" y="1137422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3" name="直接连接符 412"/>
              <p:cNvCxnSpPr/>
              <p:nvPr/>
            </p:nvCxnSpPr>
            <p:spPr>
              <a:xfrm>
                <a:off x="7226448" y="1137422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4" name="直接连接符 413"/>
              <p:cNvCxnSpPr/>
              <p:nvPr/>
            </p:nvCxnSpPr>
            <p:spPr>
              <a:xfrm>
                <a:off x="7702698" y="1137422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15" name="组合 414"/>
              <p:cNvGrpSpPr/>
              <p:nvPr/>
            </p:nvGrpSpPr>
            <p:grpSpPr>
              <a:xfrm>
                <a:off x="6507901" y="1039019"/>
                <a:ext cx="1707036" cy="455542"/>
                <a:chOff x="9176296" y="1266204"/>
                <a:chExt cx="1707036" cy="455542"/>
              </a:xfrm>
            </p:grpSpPr>
            <p:sp>
              <p:nvSpPr>
                <p:cNvPr id="416" name="文本框 50"/>
                <p:cNvSpPr txBox="1"/>
                <p:nvPr/>
              </p:nvSpPr>
              <p:spPr>
                <a:xfrm rot="17520000">
                  <a:off x="9271649" y="1367833"/>
                  <a:ext cx="417819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.3</a:t>
                  </a:r>
                </a:p>
              </p:txBody>
            </p:sp>
            <p:sp>
              <p:nvSpPr>
                <p:cNvPr id="417" name="文本框 51"/>
                <p:cNvSpPr txBox="1"/>
                <p:nvPr/>
              </p:nvSpPr>
              <p:spPr>
                <a:xfrm rot="17520000">
                  <a:off x="9433768" y="1368082"/>
                  <a:ext cx="417281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418" name="文本框 52"/>
                <p:cNvSpPr txBox="1"/>
                <p:nvPr/>
              </p:nvSpPr>
              <p:spPr>
                <a:xfrm rot="17520000">
                  <a:off x="9584763" y="1350345"/>
                  <a:ext cx="455542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419" name="文本框 55"/>
                <p:cNvSpPr txBox="1"/>
                <p:nvPr/>
              </p:nvSpPr>
              <p:spPr>
                <a:xfrm rot="17520000">
                  <a:off x="9764762" y="1367833"/>
                  <a:ext cx="417819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.3</a:t>
                  </a:r>
                </a:p>
              </p:txBody>
            </p:sp>
            <p:sp>
              <p:nvSpPr>
                <p:cNvPr id="420" name="文本框 56"/>
                <p:cNvSpPr txBox="1"/>
                <p:nvPr/>
              </p:nvSpPr>
              <p:spPr>
                <a:xfrm rot="17520000">
                  <a:off x="9923206" y="1368082"/>
                  <a:ext cx="417281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421" name="文本框 57"/>
                <p:cNvSpPr txBox="1"/>
                <p:nvPr/>
              </p:nvSpPr>
              <p:spPr>
                <a:xfrm rot="17520000">
                  <a:off x="10069328" y="1350345"/>
                  <a:ext cx="455542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422" name="文本框 58"/>
                <p:cNvSpPr txBox="1"/>
                <p:nvPr/>
              </p:nvSpPr>
              <p:spPr>
                <a:xfrm rot="17520000">
                  <a:off x="10231302" y="1367833"/>
                  <a:ext cx="417819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.3</a:t>
                  </a:r>
                </a:p>
              </p:txBody>
            </p:sp>
            <p:sp>
              <p:nvSpPr>
                <p:cNvPr id="423" name="文本框 59"/>
                <p:cNvSpPr txBox="1"/>
                <p:nvPr/>
              </p:nvSpPr>
              <p:spPr>
                <a:xfrm rot="17520000">
                  <a:off x="10378458" y="1368082"/>
                  <a:ext cx="417281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424" name="文本框 60"/>
                <p:cNvSpPr txBox="1"/>
                <p:nvPr/>
              </p:nvSpPr>
              <p:spPr>
                <a:xfrm rot="17520000">
                  <a:off x="10511932" y="1350345"/>
                  <a:ext cx="455542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425" name="文本框 61"/>
                <p:cNvSpPr txBox="1"/>
                <p:nvPr/>
              </p:nvSpPr>
              <p:spPr>
                <a:xfrm rot="17520000">
                  <a:off x="9119766" y="1375946"/>
                  <a:ext cx="400320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</p:grpSp>
        </p:grpSp>
        <p:pic>
          <p:nvPicPr>
            <p:cNvPr id="226" name="图片 225"/>
            <p:cNvPicPr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442" y="1969708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227" name="图片 226"/>
            <p:cNvPicPr>
              <a:picLocks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442" y="2188527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228" name="图片 227"/>
            <p:cNvPicPr>
              <a:picLocks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442" y="3282622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229" name="图片 228"/>
            <p:cNvPicPr>
              <a:picLocks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442" y="3501441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230" name="图片 229"/>
            <p:cNvPicPr>
              <a:picLocks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442" y="2844984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231" name="图片 230"/>
            <p:cNvPicPr>
              <a:picLocks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442" y="3063803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232" name="图片 231"/>
            <p:cNvPicPr>
              <a:picLocks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442" y="3720264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442" name="TextBox 441"/>
            <p:cNvSpPr txBox="1"/>
            <p:nvPr/>
          </p:nvSpPr>
          <p:spPr>
            <a:xfrm>
              <a:off x="5940152" y="1128590"/>
              <a:ext cx="15843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F3-FGFR1-V561M</a:t>
              </a:r>
            </a:p>
          </p:txBody>
        </p:sp>
        <p:grpSp>
          <p:nvGrpSpPr>
            <p:cNvPr id="447" name="组合 446"/>
            <p:cNvGrpSpPr/>
            <p:nvPr/>
          </p:nvGrpSpPr>
          <p:grpSpPr>
            <a:xfrm>
              <a:off x="6002865" y="1391831"/>
              <a:ext cx="1381117" cy="569519"/>
              <a:chOff x="6455513" y="925042"/>
              <a:chExt cx="1841490" cy="569519"/>
            </a:xfrm>
          </p:grpSpPr>
          <p:sp>
            <p:nvSpPr>
              <p:cNvPr id="448" name="文本框 62"/>
              <p:cNvSpPr txBox="1"/>
              <p:nvPr/>
            </p:nvSpPr>
            <p:spPr>
              <a:xfrm>
                <a:off x="7099240" y="929265"/>
                <a:ext cx="75764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ctr">
                  <a:defRPr sz="800" b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700" dirty="0">
                    <a:solidFill>
                      <a:schemeClr val="tx1"/>
                    </a:solidFill>
                  </a:rPr>
                  <a:t>TAS120</a:t>
                </a:r>
                <a:endParaRPr lang="zh-CN" altLang="en-US" sz="7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49" name="文本框 63"/>
              <p:cNvSpPr txBox="1"/>
              <p:nvPr/>
            </p:nvSpPr>
            <p:spPr>
              <a:xfrm>
                <a:off x="7615248" y="927769"/>
                <a:ext cx="68175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ctr">
                  <a:defRPr sz="800" b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700" dirty="0">
                    <a:solidFill>
                      <a:schemeClr val="tx1"/>
                    </a:solidFill>
                  </a:rPr>
                  <a:t>BGJ398</a:t>
                </a:r>
                <a:endParaRPr lang="zh-CN" altLang="en-US" sz="7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50" name="文本框 64"/>
              <p:cNvSpPr txBox="1"/>
              <p:nvPr/>
            </p:nvSpPr>
            <p:spPr>
              <a:xfrm>
                <a:off x="6455513" y="925042"/>
                <a:ext cx="88337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algn="ctr">
                  <a:defRPr sz="800" b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altLang="zh-CN" sz="700" dirty="0" err="1">
                    <a:solidFill>
                      <a:schemeClr val="tx1"/>
                    </a:solidFill>
                  </a:rPr>
                  <a:t>pemigatinib</a:t>
                </a:r>
                <a:endParaRPr lang="zh-CN" altLang="en-US" sz="700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451" name="直接连接符 450"/>
              <p:cNvCxnSpPr/>
              <p:nvPr/>
            </p:nvCxnSpPr>
            <p:spPr>
              <a:xfrm>
                <a:off x="6721623" y="1137422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2" name="直接连接符 451"/>
              <p:cNvCxnSpPr/>
              <p:nvPr/>
            </p:nvCxnSpPr>
            <p:spPr>
              <a:xfrm>
                <a:off x="7226448" y="1137422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3" name="直接连接符 452"/>
              <p:cNvCxnSpPr/>
              <p:nvPr/>
            </p:nvCxnSpPr>
            <p:spPr>
              <a:xfrm>
                <a:off x="7702698" y="1137422"/>
                <a:ext cx="43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54" name="组合 453"/>
              <p:cNvGrpSpPr/>
              <p:nvPr/>
            </p:nvGrpSpPr>
            <p:grpSpPr>
              <a:xfrm>
                <a:off x="6507901" y="1039019"/>
                <a:ext cx="1707036" cy="455542"/>
                <a:chOff x="9176296" y="1266204"/>
                <a:chExt cx="1707036" cy="455542"/>
              </a:xfrm>
            </p:grpSpPr>
            <p:sp>
              <p:nvSpPr>
                <p:cNvPr id="455" name="文本框 50"/>
                <p:cNvSpPr txBox="1"/>
                <p:nvPr/>
              </p:nvSpPr>
              <p:spPr>
                <a:xfrm rot="17520000">
                  <a:off x="9271649" y="1367833"/>
                  <a:ext cx="417819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.3</a:t>
                  </a:r>
                </a:p>
              </p:txBody>
            </p:sp>
            <p:sp>
              <p:nvSpPr>
                <p:cNvPr id="456" name="文本框 51"/>
                <p:cNvSpPr txBox="1"/>
                <p:nvPr/>
              </p:nvSpPr>
              <p:spPr>
                <a:xfrm rot="17520000">
                  <a:off x="9433768" y="1368082"/>
                  <a:ext cx="417281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457" name="文本框 52"/>
                <p:cNvSpPr txBox="1"/>
                <p:nvPr/>
              </p:nvSpPr>
              <p:spPr>
                <a:xfrm rot="17520000">
                  <a:off x="9584763" y="1350345"/>
                  <a:ext cx="455542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458" name="文本框 55"/>
                <p:cNvSpPr txBox="1"/>
                <p:nvPr/>
              </p:nvSpPr>
              <p:spPr>
                <a:xfrm rot="17520000">
                  <a:off x="9764762" y="1367833"/>
                  <a:ext cx="417819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.3</a:t>
                  </a:r>
                </a:p>
              </p:txBody>
            </p:sp>
            <p:sp>
              <p:nvSpPr>
                <p:cNvPr id="459" name="文本框 56"/>
                <p:cNvSpPr txBox="1"/>
                <p:nvPr/>
              </p:nvSpPr>
              <p:spPr>
                <a:xfrm rot="17520000">
                  <a:off x="9923206" y="1368082"/>
                  <a:ext cx="417281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460" name="文本框 57"/>
                <p:cNvSpPr txBox="1"/>
                <p:nvPr/>
              </p:nvSpPr>
              <p:spPr>
                <a:xfrm rot="17520000">
                  <a:off x="10069328" y="1350345"/>
                  <a:ext cx="455542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461" name="文本框 58"/>
                <p:cNvSpPr txBox="1"/>
                <p:nvPr/>
              </p:nvSpPr>
              <p:spPr>
                <a:xfrm rot="17520000">
                  <a:off x="10231302" y="1367833"/>
                  <a:ext cx="417819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3.3</a:t>
                  </a:r>
                </a:p>
              </p:txBody>
            </p:sp>
            <p:sp>
              <p:nvSpPr>
                <p:cNvPr id="462" name="文本框 59"/>
                <p:cNvSpPr txBox="1"/>
                <p:nvPr/>
              </p:nvSpPr>
              <p:spPr>
                <a:xfrm rot="17520000">
                  <a:off x="10378458" y="1368082"/>
                  <a:ext cx="417281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0</a:t>
                  </a:r>
                </a:p>
              </p:txBody>
            </p:sp>
            <p:sp>
              <p:nvSpPr>
                <p:cNvPr id="463" name="文本框 60"/>
                <p:cNvSpPr txBox="1"/>
                <p:nvPr/>
              </p:nvSpPr>
              <p:spPr>
                <a:xfrm rot="17520000">
                  <a:off x="10511932" y="1350345"/>
                  <a:ext cx="455542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</a:p>
              </p:txBody>
            </p:sp>
            <p:sp>
              <p:nvSpPr>
                <p:cNvPr id="464" name="文本框 61"/>
                <p:cNvSpPr txBox="1"/>
                <p:nvPr/>
              </p:nvSpPr>
              <p:spPr>
                <a:xfrm rot="17520000">
                  <a:off x="9119766" y="1375946"/>
                  <a:ext cx="400320" cy="2872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</a:p>
              </p:txBody>
            </p:sp>
          </p:grpSp>
        </p:grpSp>
        <p:sp>
          <p:nvSpPr>
            <p:cNvPr id="134" name="TextBox 133"/>
            <p:cNvSpPr txBox="1"/>
            <p:nvPr/>
          </p:nvSpPr>
          <p:spPr>
            <a:xfrm>
              <a:off x="1594212" y="1056501"/>
              <a:ext cx="4574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1" name="TextBox 470"/>
            <p:cNvSpPr txBox="1"/>
            <p:nvPr/>
          </p:nvSpPr>
          <p:spPr>
            <a:xfrm>
              <a:off x="3644659" y="1056501"/>
              <a:ext cx="4660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2" name="TextBox 471"/>
            <p:cNvSpPr txBox="1"/>
            <p:nvPr/>
          </p:nvSpPr>
          <p:spPr>
            <a:xfrm>
              <a:off x="5636699" y="1056501"/>
              <a:ext cx="4555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5" name="文本框 62"/>
            <p:cNvSpPr txBox="1"/>
            <p:nvPr/>
          </p:nvSpPr>
          <p:spPr>
            <a:xfrm>
              <a:off x="1594212" y="2377182"/>
              <a:ext cx="5114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FRS2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文本框 244"/>
            <p:cNvSpPr txBox="1"/>
            <p:nvPr/>
          </p:nvSpPr>
          <p:spPr>
            <a:xfrm>
              <a:off x="1594211" y="2594667"/>
              <a:ext cx="5114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S2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8" name="图片 177"/>
            <p:cNvPicPr>
              <a:picLocks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24970" y="2406738"/>
              <a:ext cx="1216152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179" name="图片 178"/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26122" y="2625253"/>
              <a:ext cx="1215000" cy="164436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196" name="文本框 1"/>
            <p:cNvSpPr txBox="1"/>
            <p:nvPr/>
          </p:nvSpPr>
          <p:spPr>
            <a:xfrm>
              <a:off x="3705788" y="3441099"/>
              <a:ext cx="4155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K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文本框 2"/>
            <p:cNvSpPr txBox="1"/>
            <p:nvPr/>
          </p:nvSpPr>
          <p:spPr>
            <a:xfrm>
              <a:off x="3527167" y="3664597"/>
              <a:ext cx="5941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文本框 3"/>
            <p:cNvSpPr txBox="1"/>
            <p:nvPr/>
          </p:nvSpPr>
          <p:spPr>
            <a:xfrm>
              <a:off x="3589315" y="3217603"/>
              <a:ext cx="5320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文本框 5"/>
            <p:cNvSpPr txBox="1"/>
            <p:nvPr/>
          </p:nvSpPr>
          <p:spPr>
            <a:xfrm>
              <a:off x="3589315" y="2994107"/>
              <a:ext cx="5320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文本框 7"/>
            <p:cNvSpPr txBox="1"/>
            <p:nvPr/>
          </p:nvSpPr>
          <p:spPr>
            <a:xfrm>
              <a:off x="3609918" y="2112350"/>
              <a:ext cx="5114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文本框 8"/>
            <p:cNvSpPr txBox="1"/>
            <p:nvPr/>
          </p:nvSpPr>
          <p:spPr>
            <a:xfrm>
              <a:off x="3503527" y="1888854"/>
              <a:ext cx="6178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FGFR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2" name="文本框 9"/>
            <p:cNvSpPr txBox="1"/>
            <p:nvPr/>
          </p:nvSpPr>
          <p:spPr>
            <a:xfrm>
              <a:off x="3527167" y="2770611"/>
              <a:ext cx="5941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K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矩形 202"/>
            <p:cNvSpPr/>
            <p:nvPr/>
          </p:nvSpPr>
          <p:spPr>
            <a:xfrm>
              <a:off x="3416569" y="1692253"/>
              <a:ext cx="79701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.</a:t>
              </a:r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（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）</a:t>
              </a:r>
            </a:p>
          </p:txBody>
        </p:sp>
        <p:sp>
          <p:nvSpPr>
            <p:cNvPr id="204" name="文本框 62"/>
            <p:cNvSpPr txBox="1"/>
            <p:nvPr/>
          </p:nvSpPr>
          <p:spPr>
            <a:xfrm>
              <a:off x="3611038" y="2338510"/>
              <a:ext cx="5114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FRS2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文本框 244"/>
            <p:cNvSpPr txBox="1"/>
            <p:nvPr/>
          </p:nvSpPr>
          <p:spPr>
            <a:xfrm>
              <a:off x="3611037" y="2555995"/>
              <a:ext cx="5114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S2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6" name="文本框 1"/>
            <p:cNvSpPr txBox="1"/>
            <p:nvPr/>
          </p:nvSpPr>
          <p:spPr>
            <a:xfrm>
              <a:off x="5631860" y="3470667"/>
              <a:ext cx="4155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RK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7" name="文本框 2"/>
            <p:cNvSpPr txBox="1"/>
            <p:nvPr/>
          </p:nvSpPr>
          <p:spPr>
            <a:xfrm>
              <a:off x="5357547" y="3694165"/>
              <a:ext cx="6898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文本框 3"/>
            <p:cNvSpPr txBox="1"/>
            <p:nvPr/>
          </p:nvSpPr>
          <p:spPr>
            <a:xfrm>
              <a:off x="5515386" y="3247171"/>
              <a:ext cx="5320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ERK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文本框 5"/>
            <p:cNvSpPr txBox="1"/>
            <p:nvPr/>
          </p:nvSpPr>
          <p:spPr>
            <a:xfrm>
              <a:off x="5584859" y="3023675"/>
              <a:ext cx="4625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K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0" name="文本框 7"/>
            <p:cNvSpPr txBox="1"/>
            <p:nvPr/>
          </p:nvSpPr>
          <p:spPr>
            <a:xfrm>
              <a:off x="5535990" y="2141918"/>
              <a:ext cx="5114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文本框 8"/>
            <p:cNvSpPr txBox="1"/>
            <p:nvPr/>
          </p:nvSpPr>
          <p:spPr>
            <a:xfrm>
              <a:off x="5515386" y="1918422"/>
              <a:ext cx="5320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FGFR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文本框 9"/>
            <p:cNvSpPr txBox="1"/>
            <p:nvPr/>
          </p:nvSpPr>
          <p:spPr>
            <a:xfrm>
              <a:off x="5519685" y="2800179"/>
              <a:ext cx="5277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K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矩形 220"/>
            <p:cNvSpPr/>
            <p:nvPr/>
          </p:nvSpPr>
          <p:spPr>
            <a:xfrm>
              <a:off x="5342641" y="1721821"/>
              <a:ext cx="79701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c.</a:t>
              </a:r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（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）</a:t>
              </a:r>
            </a:p>
          </p:txBody>
        </p:sp>
        <p:sp>
          <p:nvSpPr>
            <p:cNvPr id="222" name="文本框 62"/>
            <p:cNvSpPr txBox="1"/>
            <p:nvPr/>
          </p:nvSpPr>
          <p:spPr>
            <a:xfrm>
              <a:off x="5537109" y="2368078"/>
              <a:ext cx="5114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FRS2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文本框 244"/>
            <p:cNvSpPr txBox="1"/>
            <p:nvPr/>
          </p:nvSpPr>
          <p:spPr>
            <a:xfrm>
              <a:off x="5537109" y="2585563"/>
              <a:ext cx="5114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S2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24" name="图片 223"/>
            <p:cNvPicPr>
              <a:picLocks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6204" y="2407346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225" name="图片 224"/>
            <p:cNvPicPr>
              <a:picLocks noChangeAspect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6204" y="2626165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234" name="图片 233"/>
            <p:cNvPicPr>
              <a:picLocks/>
            </p:cNvPicPr>
            <p:nvPr/>
          </p:nvPicPr>
          <p:blipFill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442" y="2407346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pic>
          <p:nvPicPr>
            <p:cNvPr id="237" name="图片 236"/>
            <p:cNvPicPr>
              <a:picLocks noChangeAspect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38442" y="2626165"/>
              <a:ext cx="1215000" cy="16200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30549489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矩形 58"/>
          <p:cNvSpPr/>
          <p:nvPr/>
        </p:nvSpPr>
        <p:spPr>
          <a:xfrm>
            <a:off x="676703" y="4453155"/>
            <a:ext cx="726128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GZD824 induces degradation of FGFR1 through the ubiquitin proteasome-mediated proteolysis process in Ba/F3-FGFR1 cells. </a:t>
            </a:r>
          </a:p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Ba/F3-FGFR1 cells were treated with or without GZD824  with indicated concentration for 4hr in the presence of MG132 (10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then FGFR1 protein levels were detected by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ster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ting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; B) Ba/F3-FGFR1 cells were treated with DMSO or GZD824 (30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r 4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presence of MG132 and cell lysates were subjected to immunoprecipitation with anti-FGFR1 and the ubiquitination of FGFR protein was examined.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" name="组合 30"/>
          <p:cNvGrpSpPr/>
          <p:nvPr/>
        </p:nvGrpSpPr>
        <p:grpSpPr>
          <a:xfrm>
            <a:off x="2269567" y="1221118"/>
            <a:ext cx="4457114" cy="2869856"/>
            <a:chOff x="3026090" y="1221116"/>
            <a:chExt cx="5942818" cy="2869855"/>
          </a:xfrm>
        </p:grpSpPr>
        <p:pic>
          <p:nvPicPr>
            <p:cNvPr id="66" name="图片 6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64277" y="2769015"/>
              <a:ext cx="2160000" cy="216270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67" name="文本框 17"/>
            <p:cNvSpPr txBox="1"/>
            <p:nvPr/>
          </p:nvSpPr>
          <p:spPr>
            <a:xfrm>
              <a:off x="3026090" y="3055905"/>
              <a:ext cx="90335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文本框 7"/>
            <p:cNvSpPr txBox="1"/>
            <p:nvPr/>
          </p:nvSpPr>
          <p:spPr>
            <a:xfrm>
              <a:off x="3247525" y="2784684"/>
              <a:ext cx="6819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9" name="图片 6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69329" y="3059863"/>
              <a:ext cx="2160000" cy="162066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70" name="文本框 21"/>
            <p:cNvSpPr txBox="1"/>
            <p:nvPr/>
          </p:nvSpPr>
          <p:spPr>
            <a:xfrm>
              <a:off x="3961146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文本框 22"/>
            <p:cNvSpPr txBox="1"/>
            <p:nvPr/>
          </p:nvSpPr>
          <p:spPr>
            <a:xfrm>
              <a:off x="4133530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＋</a:t>
              </a:r>
            </a:p>
          </p:txBody>
        </p:sp>
        <p:sp>
          <p:nvSpPr>
            <p:cNvPr id="72" name="文本框 23"/>
            <p:cNvSpPr txBox="1"/>
            <p:nvPr/>
          </p:nvSpPr>
          <p:spPr>
            <a:xfrm>
              <a:off x="4319562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文本框 24"/>
            <p:cNvSpPr txBox="1"/>
            <p:nvPr/>
          </p:nvSpPr>
          <p:spPr>
            <a:xfrm>
              <a:off x="4478298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＋</a:t>
              </a:r>
            </a:p>
          </p:txBody>
        </p:sp>
        <p:sp>
          <p:nvSpPr>
            <p:cNvPr id="74" name="文本框 25"/>
            <p:cNvSpPr txBox="1"/>
            <p:nvPr/>
          </p:nvSpPr>
          <p:spPr>
            <a:xfrm>
              <a:off x="4677978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文本框 26"/>
            <p:cNvSpPr txBox="1"/>
            <p:nvPr/>
          </p:nvSpPr>
          <p:spPr>
            <a:xfrm>
              <a:off x="4823066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＋</a:t>
              </a:r>
            </a:p>
          </p:txBody>
        </p:sp>
        <p:sp>
          <p:nvSpPr>
            <p:cNvPr id="76" name="文本框 27"/>
            <p:cNvSpPr txBox="1"/>
            <p:nvPr/>
          </p:nvSpPr>
          <p:spPr>
            <a:xfrm>
              <a:off x="5022746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28"/>
            <p:cNvSpPr txBox="1"/>
            <p:nvPr/>
          </p:nvSpPr>
          <p:spPr>
            <a:xfrm>
              <a:off x="5167834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＋</a:t>
              </a:r>
            </a:p>
          </p:txBody>
        </p:sp>
        <p:sp>
          <p:nvSpPr>
            <p:cNvPr id="78" name="文本框 29"/>
            <p:cNvSpPr txBox="1"/>
            <p:nvPr/>
          </p:nvSpPr>
          <p:spPr>
            <a:xfrm>
              <a:off x="5381162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30"/>
            <p:cNvSpPr txBox="1"/>
            <p:nvPr/>
          </p:nvSpPr>
          <p:spPr>
            <a:xfrm>
              <a:off x="5512602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＋</a:t>
              </a:r>
            </a:p>
          </p:txBody>
        </p:sp>
        <p:sp>
          <p:nvSpPr>
            <p:cNvPr id="80" name="文本框 31"/>
            <p:cNvSpPr txBox="1"/>
            <p:nvPr/>
          </p:nvSpPr>
          <p:spPr>
            <a:xfrm>
              <a:off x="5725930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32"/>
            <p:cNvSpPr txBox="1"/>
            <p:nvPr/>
          </p:nvSpPr>
          <p:spPr>
            <a:xfrm>
              <a:off x="5857374" y="2520099"/>
              <a:ext cx="2931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＋</a:t>
              </a:r>
            </a:p>
          </p:txBody>
        </p:sp>
        <p:sp>
          <p:nvSpPr>
            <p:cNvPr id="82" name="文本框 33"/>
            <p:cNvSpPr txBox="1"/>
            <p:nvPr/>
          </p:nvSpPr>
          <p:spPr>
            <a:xfrm>
              <a:off x="4058825" y="2292024"/>
              <a:ext cx="3003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文本框 34"/>
            <p:cNvSpPr txBox="1"/>
            <p:nvPr/>
          </p:nvSpPr>
          <p:spPr>
            <a:xfrm>
              <a:off x="4254337" y="2292024"/>
              <a:ext cx="4657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7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文本框 35"/>
            <p:cNvSpPr txBox="1"/>
            <p:nvPr/>
          </p:nvSpPr>
          <p:spPr>
            <a:xfrm>
              <a:off x="4525360" y="2292024"/>
              <a:ext cx="58993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.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文本框 36"/>
            <p:cNvSpPr txBox="1"/>
            <p:nvPr/>
          </p:nvSpPr>
          <p:spPr>
            <a:xfrm>
              <a:off x="4993712" y="2304551"/>
              <a:ext cx="50542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3.3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文本框 37"/>
            <p:cNvSpPr txBox="1"/>
            <p:nvPr/>
          </p:nvSpPr>
          <p:spPr>
            <a:xfrm>
              <a:off x="5361659" y="2304551"/>
              <a:ext cx="4658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文本框 38"/>
            <p:cNvSpPr txBox="1"/>
            <p:nvPr/>
          </p:nvSpPr>
          <p:spPr>
            <a:xfrm>
              <a:off x="5675348" y="2304551"/>
              <a:ext cx="6126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文本框 7"/>
            <p:cNvSpPr txBox="1"/>
            <p:nvPr/>
          </p:nvSpPr>
          <p:spPr>
            <a:xfrm>
              <a:off x="3026091" y="2506451"/>
              <a:ext cx="90335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G132 (10uM)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文本框 7"/>
            <p:cNvSpPr txBox="1"/>
            <p:nvPr/>
          </p:nvSpPr>
          <p:spPr>
            <a:xfrm>
              <a:off x="3247525" y="2266972"/>
              <a:ext cx="68191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ZD824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0" name="图片 8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347556" y="3797640"/>
              <a:ext cx="633328" cy="293331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91" name="TextBox 75"/>
            <p:cNvSpPr txBox="1"/>
            <p:nvPr/>
          </p:nvSpPr>
          <p:spPr>
            <a:xfrm>
              <a:off x="7150894" y="1345715"/>
              <a:ext cx="14413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/F3</a:t>
              </a:r>
              <a:r>
                <a:rPr lang="en-US" altLang="zh-CN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1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文本框 5"/>
            <p:cNvSpPr txBox="1"/>
            <p:nvPr/>
          </p:nvSpPr>
          <p:spPr>
            <a:xfrm>
              <a:off x="6288023" y="3842578"/>
              <a:ext cx="9643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</a:p>
          </p:txBody>
        </p:sp>
        <p:pic>
          <p:nvPicPr>
            <p:cNvPr id="93" name="图片 9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347556" y="3463541"/>
              <a:ext cx="633981" cy="284935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sp>
          <p:nvSpPr>
            <p:cNvPr id="94" name="文本框 10"/>
            <p:cNvSpPr txBox="1"/>
            <p:nvPr/>
          </p:nvSpPr>
          <p:spPr>
            <a:xfrm>
              <a:off x="6425420" y="3474147"/>
              <a:ext cx="8338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1</a:t>
              </a:r>
            </a:p>
          </p:txBody>
        </p:sp>
        <p:pic>
          <p:nvPicPr>
            <p:cNvPr id="95" name="图片 9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347556" y="2065617"/>
              <a:ext cx="609600" cy="1323975"/>
            </a:xfrm>
            <a:prstGeom prst="rect">
              <a:avLst/>
            </a:prstGeom>
            <a:ln>
              <a:solidFill>
                <a:schemeClr val="bg1">
                  <a:lumMod val="50000"/>
                </a:schemeClr>
              </a:solidFill>
            </a:ln>
          </p:spPr>
        </p:pic>
        <p:cxnSp>
          <p:nvCxnSpPr>
            <p:cNvPr id="96" name="直接连接符 95"/>
            <p:cNvCxnSpPr/>
            <p:nvPr/>
          </p:nvCxnSpPr>
          <p:spPr>
            <a:xfrm>
              <a:off x="8079453" y="3487610"/>
              <a:ext cx="0" cy="52498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文本框 40"/>
            <p:cNvSpPr txBox="1"/>
            <p:nvPr/>
          </p:nvSpPr>
          <p:spPr>
            <a:xfrm>
              <a:off x="6182938" y="1868097"/>
              <a:ext cx="122979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ZD824(</a:t>
              </a:r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M</a:t>
              </a:r>
              <a:r>
                <a: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）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文本框 41"/>
            <p:cNvSpPr txBox="1"/>
            <p:nvPr/>
          </p:nvSpPr>
          <p:spPr>
            <a:xfrm>
              <a:off x="6355802" y="1671971"/>
              <a:ext cx="10052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G132(</a:t>
              </a:r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μM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</a:p>
          </p:txBody>
        </p:sp>
        <p:sp>
          <p:nvSpPr>
            <p:cNvPr id="99" name="文本框 42"/>
            <p:cNvSpPr txBox="1"/>
            <p:nvPr/>
          </p:nvSpPr>
          <p:spPr>
            <a:xfrm>
              <a:off x="7358010" y="1671971"/>
              <a:ext cx="51357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文本框 43"/>
            <p:cNvSpPr txBox="1"/>
            <p:nvPr/>
          </p:nvSpPr>
          <p:spPr>
            <a:xfrm>
              <a:off x="7646556" y="1671971"/>
              <a:ext cx="4828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文本框 44"/>
            <p:cNvSpPr txBox="1"/>
            <p:nvPr/>
          </p:nvSpPr>
          <p:spPr>
            <a:xfrm>
              <a:off x="7378186" y="1868097"/>
              <a:ext cx="2885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文本框 45"/>
            <p:cNvSpPr txBox="1"/>
            <p:nvPr/>
          </p:nvSpPr>
          <p:spPr>
            <a:xfrm>
              <a:off x="7663917" y="1868097"/>
              <a:ext cx="4945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文本框 2"/>
            <p:cNvSpPr txBox="1"/>
            <p:nvPr/>
          </p:nvSpPr>
          <p:spPr>
            <a:xfrm>
              <a:off x="7957809" y="2453538"/>
              <a:ext cx="1011099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P; FGFR1</a:t>
              </a:r>
            </a:p>
            <a:p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B: Ubiquitin</a:t>
              </a:r>
            </a:p>
            <a:p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文本框 26"/>
            <p:cNvSpPr txBox="1"/>
            <p:nvPr/>
          </p:nvSpPr>
          <p:spPr>
            <a:xfrm>
              <a:off x="8129441" y="3631094"/>
              <a:ext cx="8394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pu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TextBox 75"/>
            <p:cNvSpPr txBox="1"/>
            <p:nvPr/>
          </p:nvSpPr>
          <p:spPr>
            <a:xfrm>
              <a:off x="4254337" y="1903204"/>
              <a:ext cx="12896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/F3</a:t>
              </a:r>
              <a:r>
                <a:rPr lang="en-US" altLang="zh-CN" sz="12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1</a:t>
              </a:r>
              <a:endPara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049785" y="1438048"/>
              <a:ext cx="6459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r">
                <a:defRPr sz="12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dirty="0"/>
                <a:t>A)</a:t>
              </a:r>
              <a:endParaRPr lang="zh-CN" altLang="en-US" dirty="0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6218584" y="1221116"/>
              <a:ext cx="62378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r">
                <a:defRPr sz="12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dirty="0"/>
                <a:t>B)</a:t>
              </a:r>
              <a:endParaRPr lang="zh-CN" altLang="en-US" dirty="0"/>
            </a:p>
          </p:txBody>
        </p:sp>
        <p:cxnSp>
          <p:nvCxnSpPr>
            <p:cNvPr id="6" name="直接连接符 5"/>
            <p:cNvCxnSpPr/>
            <p:nvPr/>
          </p:nvCxnSpPr>
          <p:spPr>
            <a:xfrm>
              <a:off x="4068304" y="2530179"/>
              <a:ext cx="2118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接连接符 107"/>
            <p:cNvCxnSpPr/>
            <p:nvPr/>
          </p:nvCxnSpPr>
          <p:spPr>
            <a:xfrm>
              <a:off x="4419450" y="2530179"/>
              <a:ext cx="2118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/>
            <p:cNvCxnSpPr/>
            <p:nvPr/>
          </p:nvCxnSpPr>
          <p:spPr>
            <a:xfrm>
              <a:off x="4770596" y="2530179"/>
              <a:ext cx="2118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接连接符 109"/>
            <p:cNvCxnSpPr/>
            <p:nvPr/>
          </p:nvCxnSpPr>
          <p:spPr>
            <a:xfrm>
              <a:off x="5121742" y="2530179"/>
              <a:ext cx="2118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接连接符 110"/>
            <p:cNvCxnSpPr/>
            <p:nvPr/>
          </p:nvCxnSpPr>
          <p:spPr>
            <a:xfrm>
              <a:off x="5472888" y="2530179"/>
              <a:ext cx="2118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接连接符 111"/>
            <p:cNvCxnSpPr/>
            <p:nvPr/>
          </p:nvCxnSpPr>
          <p:spPr>
            <a:xfrm>
              <a:off x="5824032" y="2530179"/>
              <a:ext cx="2118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421210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9431340"/>
              </p:ext>
            </p:extLst>
          </p:nvPr>
        </p:nvGraphicFramePr>
        <p:xfrm>
          <a:off x="3294425" y="739161"/>
          <a:ext cx="2183024" cy="19114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4510964"/>
              </p:ext>
            </p:extLst>
          </p:nvPr>
        </p:nvGraphicFramePr>
        <p:xfrm>
          <a:off x="1014752" y="739161"/>
          <a:ext cx="2183024" cy="19114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1411809"/>
              </p:ext>
            </p:extLst>
          </p:nvPr>
        </p:nvGraphicFramePr>
        <p:xfrm>
          <a:off x="5638718" y="739163"/>
          <a:ext cx="2198837" cy="18870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755577" y="600663"/>
            <a:ext cx="444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175523" y="600663"/>
            <a:ext cx="3883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488525" y="600663"/>
            <a:ext cx="379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892719" y="3085313"/>
            <a:ext cx="7229537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zh-CN" sz="1200" b="1" dirty="0">
                <a:solidFill>
                  <a:prstClr val="black"/>
                </a:solidFill>
                <a:latin typeface="Times New Roman"/>
                <a:cs typeface="Times New Roman"/>
              </a:rPr>
              <a:t>Figure S4</a:t>
            </a:r>
            <a:r>
              <a:rPr lang="en-US" altLang="zh-CN" sz="1200" dirty="0">
                <a:solidFill>
                  <a:prstClr val="black"/>
                </a:solidFill>
                <a:latin typeface="Times New Roman"/>
                <a:cs typeface="Times New Roman"/>
              </a:rPr>
              <a:t>. </a:t>
            </a:r>
            <a:r>
              <a:rPr lang="en-US" altLang="zh-CN" sz="1200" b="1" dirty="0">
                <a:solidFill>
                  <a:prstClr val="black"/>
                </a:solidFill>
                <a:latin typeface="Times New Roman"/>
                <a:cs typeface="Times New Roman"/>
              </a:rPr>
              <a:t>In vivo effect of  GZD824 on body weight in Ba/F3-TEL-FGFR1, Ba/F3-TEL-FGFR1-V561M and Ba/F3-TEL-FGFR1-V561F xenograft model. </a:t>
            </a:r>
            <a:endParaRPr lang="en-US" altLang="zh-CN" sz="1200" dirty="0">
              <a:solidFill>
                <a:prstClr val="black"/>
              </a:solidFill>
              <a:latin typeface="Times New Roman"/>
              <a:cs typeface="Times New Roman"/>
            </a:endParaRPr>
          </a:p>
          <a:p>
            <a:pPr lvl="0"/>
            <a:r>
              <a:rPr lang="en-US" altLang="zh-CN" sz="1200" dirty="0">
                <a:solidFill>
                  <a:prstClr val="black"/>
                </a:solidFill>
                <a:latin typeface="Times New Roman"/>
                <a:cs typeface="Times New Roman"/>
              </a:rPr>
              <a:t>A) Effect of GZD824 on body weight in Ba/F3-TEL-FGFR1 model (B) Effect of GZD824 on body weight Ba/F3-TEL-FGFR1-V561F model. (C) Effect of GZD824 on body weight in Ba/F3-TEL-FGFR1-V561M model. CB17-SCID mice </a:t>
            </a:r>
            <a:r>
              <a:rPr lang="en-US" altLang="zh-CN" sz="1200" dirty="0" err="1">
                <a:solidFill>
                  <a:prstClr val="black"/>
                </a:solidFill>
                <a:latin typeface="Times New Roman"/>
                <a:cs typeface="Times New Roman"/>
              </a:rPr>
              <a:t>xenografted</a:t>
            </a:r>
            <a:r>
              <a:rPr lang="en-US" altLang="zh-CN" sz="1200" dirty="0">
                <a:solidFill>
                  <a:prstClr val="black"/>
                </a:solidFill>
                <a:latin typeface="Times New Roman"/>
                <a:cs typeface="Times New Roman"/>
              </a:rPr>
              <a:t> models were orally dosed once every two day (q2d) for 12 days with vehicle or GZD824, or once a day (</a:t>
            </a:r>
            <a:r>
              <a:rPr lang="en-US" altLang="zh-CN" sz="1200" dirty="0" err="1">
                <a:solidFill>
                  <a:prstClr val="black"/>
                </a:solidFill>
                <a:latin typeface="Times New Roman"/>
                <a:cs typeface="Times New Roman"/>
              </a:rPr>
              <a:t>qd</a:t>
            </a:r>
            <a:r>
              <a:rPr lang="en-US" altLang="zh-CN" sz="1200" dirty="0">
                <a:solidFill>
                  <a:prstClr val="black"/>
                </a:solidFill>
                <a:latin typeface="Times New Roman"/>
                <a:cs typeface="Times New Roman"/>
              </a:rPr>
              <a:t>) with BGJ398. Body weight were measured every two day.(*p &lt; 0.05, **p &lt; 0.01).</a:t>
            </a:r>
          </a:p>
          <a:p>
            <a:endParaRPr lang="zh-CN" altLang="en-US" sz="1200" dirty="0">
              <a:solidFill>
                <a:prstClr val="black"/>
              </a:solidFill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818735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标题 1"/>
          <p:cNvSpPr txBox="1">
            <a:spLocks/>
          </p:cNvSpPr>
          <p:nvPr/>
        </p:nvSpPr>
        <p:spPr>
          <a:xfrm>
            <a:off x="1104932" y="4772503"/>
            <a:ext cx="6891340" cy="1307365"/>
          </a:xfrm>
          <a:prstGeom prst="rect">
            <a:avLst/>
          </a:prstGeom>
        </p:spPr>
        <p:txBody>
          <a:bodyPr>
            <a:normAutofit fontScale="92500"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. Effects of reported FGFRs inhibitors on cell cycle and apoptosis in Ba/F3-FGFR-WT and Ba/F3-FGFR-V561F cells</a:t>
            </a:r>
          </a:p>
          <a:p>
            <a:pPr algn="l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orted FGFRs inhibitor induced apoptosis in Ba/F3-FGFR1 but not in Ba/F3-FGFR1-V561F cells. Cells were treated with indicated concentration of BGJ398,Pemigatinib,TAS120 for 48 h before DNA labeling by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nexi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 and 7-AAD and cell apoptosis analysis by flow cytometry. B) Reported FGFRs inhibitor induced G0/G1 phase arrest in Ba/F3-FGFR1 but not in Ba/F3-FGFR1-V561F cells. Cells were treated with indicated inhibitors for 24 h before DNA labeling with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pidiu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odide and cell cycle analysis by flow cytometry. Representative flow cytometry profiles were shown here. 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2483769" y="980728"/>
            <a:ext cx="3564701" cy="3555043"/>
            <a:chOff x="1522026" y="1517790"/>
            <a:chExt cx="4752935" cy="3555043"/>
          </a:xfrm>
        </p:grpSpPr>
        <p:sp>
          <p:nvSpPr>
            <p:cNvPr id="4" name="矩形 3"/>
            <p:cNvSpPr/>
            <p:nvPr/>
          </p:nvSpPr>
          <p:spPr>
            <a:xfrm>
              <a:off x="1757879" y="2112111"/>
              <a:ext cx="14272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/F3-FGFR1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>
              <a:off x="1522026" y="3026900"/>
              <a:ext cx="16106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F3-FGFR1-V561F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3265574" y="1585105"/>
              <a:ext cx="6207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77"/>
            <p:cNvSpPr txBox="1"/>
            <p:nvPr/>
          </p:nvSpPr>
          <p:spPr>
            <a:xfrm>
              <a:off x="1751561" y="1517790"/>
              <a:ext cx="5385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30136" y="1901827"/>
              <a:ext cx="720000" cy="717323"/>
            </a:xfrm>
            <a:prstGeom prst="rect">
              <a:avLst/>
            </a:prstGeom>
          </p:spPr>
        </p:pic>
        <p:pic>
          <p:nvPicPr>
            <p:cNvPr id="16" name="图片 15"/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230135" y="2800938"/>
              <a:ext cx="720000" cy="720000"/>
            </a:xfrm>
            <a:prstGeom prst="rect">
              <a:avLst/>
            </a:prstGeom>
          </p:spPr>
        </p:pic>
        <p:pic>
          <p:nvPicPr>
            <p:cNvPr id="20" name="图片 1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60010" y="1912376"/>
              <a:ext cx="720000" cy="717323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689884" y="1901827"/>
              <a:ext cx="720000" cy="717343"/>
            </a:xfrm>
            <a:prstGeom prst="rect">
              <a:avLst/>
            </a:prstGeom>
          </p:spPr>
        </p:pic>
        <p:pic>
          <p:nvPicPr>
            <p:cNvPr id="22" name="图片 21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419757" y="1912376"/>
              <a:ext cx="720000" cy="717314"/>
            </a:xfrm>
            <a:prstGeom prst="rect">
              <a:avLst/>
            </a:prstGeom>
          </p:spPr>
        </p:pic>
        <p:pic>
          <p:nvPicPr>
            <p:cNvPr id="23" name="图片 22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969884" y="2816960"/>
              <a:ext cx="720000" cy="714000"/>
            </a:xfrm>
            <a:prstGeom prst="rect">
              <a:avLst/>
            </a:prstGeom>
          </p:spPr>
        </p:pic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703178" y="2800938"/>
              <a:ext cx="720000" cy="713966"/>
            </a:xfrm>
            <a:prstGeom prst="rect">
              <a:avLst/>
            </a:prstGeom>
          </p:spPr>
        </p:pic>
        <p:pic>
          <p:nvPicPr>
            <p:cNvPr id="25" name="图片 24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442927" y="2789988"/>
              <a:ext cx="720000" cy="717989"/>
            </a:xfrm>
            <a:prstGeom prst="rect">
              <a:avLst/>
            </a:prstGeom>
          </p:spPr>
        </p:pic>
        <p:sp>
          <p:nvSpPr>
            <p:cNvPr id="27" name="文本框 3"/>
            <p:cNvSpPr txBox="1"/>
            <p:nvPr/>
          </p:nvSpPr>
          <p:spPr>
            <a:xfrm>
              <a:off x="3207800" y="3715236"/>
              <a:ext cx="7010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2" name="图片 3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215942" y="3982428"/>
              <a:ext cx="720000" cy="447636"/>
            </a:xfrm>
            <a:prstGeom prst="rect">
              <a:avLst/>
            </a:prstGeom>
          </p:spPr>
        </p:pic>
        <p:sp>
          <p:nvSpPr>
            <p:cNvPr id="36" name="矩形 35"/>
            <p:cNvSpPr/>
            <p:nvPr/>
          </p:nvSpPr>
          <p:spPr>
            <a:xfrm>
              <a:off x="2146195" y="4021195"/>
              <a:ext cx="10467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F3-FGFR1</a:t>
              </a:r>
              <a:endPara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矩形 36"/>
            <p:cNvSpPr/>
            <p:nvPr/>
          </p:nvSpPr>
          <p:spPr>
            <a:xfrm>
              <a:off x="1757879" y="4668115"/>
              <a:ext cx="14619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F3-FGFR1-V561F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8" name="图片 37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215942" y="4622990"/>
              <a:ext cx="720000" cy="449843"/>
            </a:xfrm>
            <a:prstGeom prst="rect">
              <a:avLst/>
            </a:prstGeom>
          </p:spPr>
        </p:pic>
        <p:pic>
          <p:nvPicPr>
            <p:cNvPr id="42" name="图片 41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982565" y="3973594"/>
              <a:ext cx="720000" cy="447636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749188" y="3973595"/>
              <a:ext cx="720000" cy="447636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522548" y="3973594"/>
              <a:ext cx="720000" cy="447636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008241" y="4623370"/>
              <a:ext cx="720000" cy="449463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774864" y="4622990"/>
              <a:ext cx="720000" cy="449843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554961" y="4622990"/>
              <a:ext cx="720000" cy="449843"/>
            </a:xfrm>
            <a:prstGeom prst="rect">
              <a:avLst/>
            </a:prstGeom>
          </p:spPr>
        </p:pic>
        <p:sp>
          <p:nvSpPr>
            <p:cNvPr id="50" name="文本框 60"/>
            <p:cNvSpPr txBox="1"/>
            <p:nvPr/>
          </p:nvSpPr>
          <p:spPr>
            <a:xfrm>
              <a:off x="3982565" y="3800411"/>
              <a:ext cx="6837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nM</a:t>
              </a:r>
              <a:endParaRPr lang="zh-CN" altLang="en-US" sz="800" dirty="0"/>
            </a:p>
          </p:txBody>
        </p:sp>
        <p:sp>
          <p:nvSpPr>
            <p:cNvPr id="51" name="文本框 60"/>
            <p:cNvSpPr txBox="1"/>
            <p:nvPr/>
          </p:nvSpPr>
          <p:spPr>
            <a:xfrm>
              <a:off x="4730477" y="3797647"/>
              <a:ext cx="6837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nM</a:t>
              </a:r>
              <a:endParaRPr lang="zh-CN" altLang="en-US" sz="800" dirty="0"/>
            </a:p>
          </p:txBody>
        </p:sp>
        <p:sp>
          <p:nvSpPr>
            <p:cNvPr id="52" name="文本框 60"/>
            <p:cNvSpPr txBox="1"/>
            <p:nvPr/>
          </p:nvSpPr>
          <p:spPr>
            <a:xfrm>
              <a:off x="5515226" y="3795164"/>
              <a:ext cx="6837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nM</a:t>
              </a:r>
              <a:endParaRPr lang="zh-CN" altLang="en-US" sz="800" dirty="0"/>
            </a:p>
          </p:txBody>
        </p:sp>
        <p:sp>
          <p:nvSpPr>
            <p:cNvPr id="53" name="矩形 52"/>
            <p:cNvSpPr/>
            <p:nvPr/>
          </p:nvSpPr>
          <p:spPr>
            <a:xfrm>
              <a:off x="3971804" y="3606022"/>
              <a:ext cx="71857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GJ398</a:t>
              </a:r>
              <a:endParaRPr lang="zh-CN" altLang="en-US" sz="800" b="1" dirty="0"/>
            </a:p>
          </p:txBody>
        </p:sp>
        <p:sp>
          <p:nvSpPr>
            <p:cNvPr id="54" name="矩形 53"/>
            <p:cNvSpPr/>
            <p:nvPr/>
          </p:nvSpPr>
          <p:spPr>
            <a:xfrm>
              <a:off x="5458462" y="3606022"/>
              <a:ext cx="71857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S120</a:t>
              </a:r>
            </a:p>
          </p:txBody>
        </p:sp>
        <p:sp>
          <p:nvSpPr>
            <p:cNvPr id="55" name="矩形 54"/>
            <p:cNvSpPr/>
            <p:nvPr/>
          </p:nvSpPr>
          <p:spPr>
            <a:xfrm>
              <a:off x="4594366" y="3606602"/>
              <a:ext cx="95368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migatinib</a:t>
              </a:r>
            </a:p>
          </p:txBody>
        </p:sp>
        <p:sp>
          <p:nvSpPr>
            <p:cNvPr id="39" name="TextBox 177"/>
            <p:cNvSpPr txBox="1"/>
            <p:nvPr/>
          </p:nvSpPr>
          <p:spPr>
            <a:xfrm>
              <a:off x="1618035" y="3603139"/>
              <a:ext cx="6282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60"/>
            <p:cNvSpPr txBox="1"/>
            <p:nvPr/>
          </p:nvSpPr>
          <p:spPr>
            <a:xfrm>
              <a:off x="3886310" y="2604065"/>
              <a:ext cx="7333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0nM</a:t>
              </a:r>
              <a:endParaRPr lang="zh-CN" altLang="en-US" sz="800" dirty="0"/>
            </a:p>
          </p:txBody>
        </p:sp>
        <p:sp>
          <p:nvSpPr>
            <p:cNvPr id="41" name="文本框 60"/>
            <p:cNvSpPr txBox="1"/>
            <p:nvPr/>
          </p:nvSpPr>
          <p:spPr>
            <a:xfrm>
              <a:off x="4594366" y="2601300"/>
              <a:ext cx="7732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0nM</a:t>
              </a:r>
              <a:endParaRPr lang="zh-CN" altLang="en-US" sz="800" dirty="0"/>
            </a:p>
          </p:txBody>
        </p:sp>
        <p:sp>
          <p:nvSpPr>
            <p:cNvPr id="48" name="文本框 60"/>
            <p:cNvSpPr txBox="1"/>
            <p:nvPr/>
          </p:nvSpPr>
          <p:spPr>
            <a:xfrm>
              <a:off x="5367577" y="2598819"/>
              <a:ext cx="7847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0nM</a:t>
              </a:r>
              <a:endParaRPr lang="zh-CN" altLang="en-US" sz="800" dirty="0"/>
            </a:p>
          </p:txBody>
        </p:sp>
        <p:sp>
          <p:nvSpPr>
            <p:cNvPr id="59" name="文本框 60"/>
            <p:cNvSpPr txBox="1"/>
            <p:nvPr/>
          </p:nvSpPr>
          <p:spPr>
            <a:xfrm>
              <a:off x="3970416" y="1690279"/>
              <a:ext cx="6837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nM</a:t>
              </a:r>
              <a:endParaRPr lang="zh-CN" altLang="en-US" sz="800" dirty="0"/>
            </a:p>
          </p:txBody>
        </p:sp>
        <p:sp>
          <p:nvSpPr>
            <p:cNvPr id="60" name="文本框 60"/>
            <p:cNvSpPr txBox="1"/>
            <p:nvPr/>
          </p:nvSpPr>
          <p:spPr>
            <a:xfrm>
              <a:off x="4718328" y="1687513"/>
              <a:ext cx="6837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nM</a:t>
              </a:r>
              <a:endParaRPr lang="zh-CN" altLang="en-US" sz="800" dirty="0"/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5503076" y="1685031"/>
              <a:ext cx="6837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nM</a:t>
              </a:r>
              <a:endParaRPr lang="zh-CN" altLang="en-US" sz="800" dirty="0"/>
            </a:p>
          </p:txBody>
        </p:sp>
        <p:sp>
          <p:nvSpPr>
            <p:cNvPr id="62" name="矩形 61"/>
            <p:cNvSpPr/>
            <p:nvPr/>
          </p:nvSpPr>
          <p:spPr>
            <a:xfrm>
              <a:off x="4067814" y="1518370"/>
              <a:ext cx="718573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GJ398</a:t>
              </a:r>
              <a:endParaRPr lang="zh-CN" altLang="en-US" sz="800" b="1" dirty="0"/>
            </a:p>
          </p:txBody>
        </p:sp>
        <p:sp>
          <p:nvSpPr>
            <p:cNvPr id="63" name="矩形 62"/>
            <p:cNvSpPr/>
            <p:nvPr/>
          </p:nvSpPr>
          <p:spPr>
            <a:xfrm>
              <a:off x="5507976" y="1518370"/>
              <a:ext cx="71857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S120</a:t>
              </a:r>
            </a:p>
          </p:txBody>
        </p:sp>
        <p:sp>
          <p:nvSpPr>
            <p:cNvPr id="64" name="矩形 63"/>
            <p:cNvSpPr/>
            <p:nvPr/>
          </p:nvSpPr>
          <p:spPr>
            <a:xfrm>
              <a:off x="4696804" y="1518370"/>
              <a:ext cx="95368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migatinib</a:t>
              </a:r>
            </a:p>
          </p:txBody>
        </p:sp>
        <p:sp>
          <p:nvSpPr>
            <p:cNvPr id="65" name="文本框 60"/>
            <p:cNvSpPr txBox="1"/>
            <p:nvPr/>
          </p:nvSpPr>
          <p:spPr>
            <a:xfrm>
              <a:off x="3886310" y="4433295"/>
              <a:ext cx="8116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0nM</a:t>
              </a:r>
              <a:endParaRPr lang="zh-CN" altLang="en-US" sz="800" dirty="0"/>
            </a:p>
          </p:txBody>
        </p:sp>
        <p:sp>
          <p:nvSpPr>
            <p:cNvPr id="66" name="文本框 60"/>
            <p:cNvSpPr txBox="1"/>
            <p:nvPr/>
          </p:nvSpPr>
          <p:spPr>
            <a:xfrm>
              <a:off x="4680010" y="4430529"/>
              <a:ext cx="7658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0nM</a:t>
              </a:r>
              <a:endParaRPr lang="zh-CN" altLang="en-US" sz="800" dirty="0"/>
            </a:p>
          </p:txBody>
        </p:sp>
        <p:sp>
          <p:nvSpPr>
            <p:cNvPr id="67" name="文本框 60"/>
            <p:cNvSpPr txBox="1"/>
            <p:nvPr/>
          </p:nvSpPr>
          <p:spPr>
            <a:xfrm>
              <a:off x="5423178" y="4428047"/>
              <a:ext cx="80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algn="ctr">
                <a:defRPr sz="10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1000nM</a:t>
              </a:r>
              <a:endParaRPr lang="zh-CN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291234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664</Words>
  <Application>Microsoft Office PowerPoint</Application>
  <PresentationFormat>全屏显示(4:3)</PresentationFormat>
  <Paragraphs>179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TKO</dc:creator>
  <cp:lastModifiedBy>NTKO</cp:lastModifiedBy>
  <cp:revision>4</cp:revision>
  <dcterms:created xsi:type="dcterms:W3CDTF">2021-01-24T01:12:14Z</dcterms:created>
  <dcterms:modified xsi:type="dcterms:W3CDTF">2021-05-19T00:37:28Z</dcterms:modified>
</cp:coreProperties>
</file>